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754AFD-733E-4F0A-A56C-4CCF838AEA10}" v="26" dt="2023-07-19T12:32:32.898"/>
    <p1510:client id="{92431F9C-91E9-4625-BCB8-AB563DB39A55}" v="1" dt="2023-07-19T13:26:32.392"/>
    <p1510:client id="{FD4A8C83-4AE1-46D4-B514-BCBE5E5C1962}" v="18" dt="2023-07-19T13:49:14.62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0" autoAdjust="0"/>
    <p:restoredTop sz="94660"/>
  </p:normalViewPr>
  <p:slideViewPr>
    <p:cSldViewPr snapToGrid="0">
      <p:cViewPr>
        <p:scale>
          <a:sx n="82" d="100"/>
          <a:sy n="82" d="100"/>
        </p:scale>
        <p:origin x="69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92431F9C-91E9-4625-BCB8-AB563DB39A55}"/>
    <pc:docChg chg="custSel modSld">
      <pc:chgData name="JUAN MANUEL LOZANO GIL" userId="618ed11e-cb2c-4b03-8ac9-a8cf52f924c9" providerId="ADAL" clId="{92431F9C-91E9-4625-BCB8-AB563DB39A55}" dt="2023-07-19T13:27:32.252" v="28" actId="1076"/>
      <pc:docMkLst>
        <pc:docMk/>
      </pc:docMkLst>
      <pc:sldChg chg="addSp delSp modSp mod">
        <pc:chgData name="JUAN MANUEL LOZANO GIL" userId="618ed11e-cb2c-4b03-8ac9-a8cf52f924c9" providerId="ADAL" clId="{92431F9C-91E9-4625-BCB8-AB563DB39A55}" dt="2023-07-19T13:27:32.252" v="28" actId="1076"/>
        <pc:sldMkLst>
          <pc:docMk/>
          <pc:sldMk cId="236126241" sldId="257"/>
        </pc:sldMkLst>
        <pc:spChg chg="mod">
          <ac:chgData name="JUAN MANUEL LOZANO GIL" userId="618ed11e-cb2c-4b03-8ac9-a8cf52f924c9" providerId="ADAL" clId="{92431F9C-91E9-4625-BCB8-AB563DB39A55}" dt="2023-07-19T13:25:13.172" v="15" actId="1076"/>
          <ac:spMkLst>
            <pc:docMk/>
            <pc:sldMk cId="236126241" sldId="257"/>
            <ac:spMk id="30" creationId="{E74161A8-0EA0-0E29-6DB3-12E4B8BA11B5}"/>
          </ac:spMkLst>
        </pc:spChg>
        <pc:spChg chg="mod">
          <ac:chgData name="JUAN MANUEL LOZANO GIL" userId="618ed11e-cb2c-4b03-8ac9-a8cf52f924c9" providerId="ADAL" clId="{92431F9C-91E9-4625-BCB8-AB563DB39A55}" dt="2023-07-19T13:25:04.733" v="13" actId="20577"/>
          <ac:spMkLst>
            <pc:docMk/>
            <pc:sldMk cId="236126241" sldId="257"/>
            <ac:spMk id="45" creationId="{98AE03D9-FDF9-A915-BF73-D611CF569C40}"/>
          </ac:spMkLst>
        </pc:spChg>
        <pc:spChg chg="mod">
          <ac:chgData name="JUAN MANUEL LOZANO GIL" userId="618ed11e-cb2c-4b03-8ac9-a8cf52f924c9" providerId="ADAL" clId="{92431F9C-91E9-4625-BCB8-AB563DB39A55}" dt="2023-07-19T13:25:18.508" v="16" actId="1076"/>
          <ac:spMkLst>
            <pc:docMk/>
            <pc:sldMk cId="236126241" sldId="257"/>
            <ac:spMk id="58" creationId="{43A1FED4-B30E-3905-0EF1-17DA44FC7FB8}"/>
          </ac:spMkLst>
        </pc:spChg>
        <pc:spChg chg="mod">
          <ac:chgData name="JUAN MANUEL LOZANO GIL" userId="618ed11e-cb2c-4b03-8ac9-a8cf52f924c9" providerId="ADAL" clId="{92431F9C-91E9-4625-BCB8-AB563DB39A55}" dt="2023-07-19T13:25:22.932" v="17" actId="1076"/>
          <ac:spMkLst>
            <pc:docMk/>
            <pc:sldMk cId="236126241" sldId="257"/>
            <ac:spMk id="79" creationId="{A9EBDE9A-BBBC-92B4-5028-2898417ACC40}"/>
          </ac:spMkLst>
        </pc:spChg>
        <pc:spChg chg="mod">
          <ac:chgData name="JUAN MANUEL LOZANO GIL" userId="618ed11e-cb2c-4b03-8ac9-a8cf52f924c9" providerId="ADAL" clId="{92431F9C-91E9-4625-BCB8-AB563DB39A55}" dt="2023-07-19T13:25:37.252" v="18" actId="1076"/>
          <ac:spMkLst>
            <pc:docMk/>
            <pc:sldMk cId="236126241" sldId="257"/>
            <ac:spMk id="111" creationId="{639D055B-F362-C4D7-03B5-C623AAFF4CA5}"/>
          </ac:spMkLst>
        </pc:spChg>
        <pc:spChg chg="mod">
          <ac:chgData name="JUAN MANUEL LOZANO GIL" userId="618ed11e-cb2c-4b03-8ac9-a8cf52f924c9" providerId="ADAL" clId="{92431F9C-91E9-4625-BCB8-AB563DB39A55}" dt="2023-07-19T13:27:26.261" v="27" actId="1076"/>
          <ac:spMkLst>
            <pc:docMk/>
            <pc:sldMk cId="236126241" sldId="257"/>
            <ac:spMk id="115" creationId="{E793D70F-9D4F-DC80-0EF0-00F9547C648D}"/>
          </ac:spMkLst>
        </pc:spChg>
        <pc:spChg chg="mod">
          <ac:chgData name="JUAN MANUEL LOZANO GIL" userId="618ed11e-cb2c-4b03-8ac9-a8cf52f924c9" providerId="ADAL" clId="{92431F9C-91E9-4625-BCB8-AB563DB39A55}" dt="2023-07-19T13:27:26.261" v="27" actId="1076"/>
          <ac:spMkLst>
            <pc:docMk/>
            <pc:sldMk cId="236126241" sldId="257"/>
            <ac:spMk id="137" creationId="{132FFF07-291A-65D4-EBB7-545D316F222E}"/>
          </ac:spMkLst>
        </pc:spChg>
        <pc:grpChg chg="mod">
          <ac:chgData name="JUAN MANUEL LOZANO GIL" userId="618ed11e-cb2c-4b03-8ac9-a8cf52f924c9" providerId="ADAL" clId="{92431F9C-91E9-4625-BCB8-AB563DB39A55}" dt="2023-07-19T13:27:32.252" v="28" actId="1076"/>
          <ac:grpSpMkLst>
            <pc:docMk/>
            <pc:sldMk cId="236126241" sldId="257"/>
            <ac:grpSpMk id="55" creationId="{310D0092-15C0-5BAC-78B3-2FF9B3258CF6}"/>
          </ac:grpSpMkLst>
        </pc:grpChg>
        <pc:grpChg chg="mod">
          <ac:chgData name="JUAN MANUEL LOZANO GIL" userId="618ed11e-cb2c-4b03-8ac9-a8cf52f924c9" providerId="ADAL" clId="{92431F9C-91E9-4625-BCB8-AB563DB39A55}" dt="2023-07-19T13:27:26.261" v="27" actId="1076"/>
          <ac:grpSpMkLst>
            <pc:docMk/>
            <pc:sldMk cId="236126241" sldId="257"/>
            <ac:grpSpMk id="121" creationId="{F7DD65EB-E362-A17D-3E97-08606792C1C6}"/>
          </ac:grpSpMkLst>
        </pc:grpChg>
        <pc:picChg chg="add mod ord modCrop">
          <ac:chgData name="JUAN MANUEL LOZANO GIL" userId="618ed11e-cb2c-4b03-8ac9-a8cf52f924c9" providerId="ADAL" clId="{92431F9C-91E9-4625-BCB8-AB563DB39A55}" dt="2023-07-19T13:27:26.261" v="27" actId="1076"/>
          <ac:picMkLst>
            <pc:docMk/>
            <pc:sldMk cId="236126241" sldId="257"/>
            <ac:picMk id="2" creationId="{BCB759F8-6631-5AC7-169B-46143ED698D1}"/>
          </ac:picMkLst>
        </pc:picChg>
        <pc:picChg chg="del">
          <ac:chgData name="JUAN MANUEL LOZANO GIL" userId="618ed11e-cb2c-4b03-8ac9-a8cf52f924c9" providerId="ADAL" clId="{92431F9C-91E9-4625-BCB8-AB563DB39A55}" dt="2023-07-19T13:25:40.387" v="19" actId="478"/>
          <ac:picMkLst>
            <pc:docMk/>
            <pc:sldMk cId="236126241" sldId="257"/>
            <ac:picMk id="114" creationId="{988EA5B1-B066-B493-0A18-66216AB290AC}"/>
          </ac:picMkLst>
        </pc:picChg>
      </pc:sldChg>
    </pc:docChg>
  </pc:docChgLst>
  <pc:docChgLst>
    <pc:chgData name="JUAN MANUEL LOZANO GIL" userId="618ed11e-cb2c-4b03-8ac9-a8cf52f924c9" providerId="ADAL" clId="{FD4A8C83-4AE1-46D4-B514-BCBE5E5C1962}"/>
    <pc:docChg chg="custSel modSld">
      <pc:chgData name="JUAN MANUEL LOZANO GIL" userId="618ed11e-cb2c-4b03-8ac9-a8cf52f924c9" providerId="ADAL" clId="{FD4A8C83-4AE1-46D4-B514-BCBE5E5C1962}" dt="2023-07-19T13:50:16.650" v="248" actId="1036"/>
      <pc:docMkLst>
        <pc:docMk/>
      </pc:docMkLst>
      <pc:sldChg chg="addSp delSp modSp mod">
        <pc:chgData name="JUAN MANUEL LOZANO GIL" userId="618ed11e-cb2c-4b03-8ac9-a8cf52f924c9" providerId="ADAL" clId="{FD4A8C83-4AE1-46D4-B514-BCBE5E5C1962}" dt="2023-07-19T13:50:16.650" v="248" actId="1036"/>
        <pc:sldMkLst>
          <pc:docMk/>
          <pc:sldMk cId="236126241" sldId="257"/>
        </pc:sldMkLst>
        <pc:spChg chg="del">
          <ac:chgData name="JUAN MANUEL LOZANO GIL" userId="618ed11e-cb2c-4b03-8ac9-a8cf52f924c9" providerId="ADAL" clId="{FD4A8C83-4AE1-46D4-B514-BCBE5E5C1962}" dt="2023-07-19T13:37:55.947" v="48" actId="478"/>
          <ac:spMkLst>
            <pc:docMk/>
            <pc:sldMk cId="236126241" sldId="257"/>
            <ac:spMk id="10" creationId="{16ADC64E-B653-5748-8F85-99419827A74F}"/>
          </ac:spMkLst>
        </pc:spChg>
        <pc:spChg chg="del">
          <ac:chgData name="JUAN MANUEL LOZANO GIL" userId="618ed11e-cb2c-4b03-8ac9-a8cf52f924c9" providerId="ADAL" clId="{FD4A8C83-4AE1-46D4-B514-BCBE5E5C1962}" dt="2023-07-19T13:38:08.419" v="50" actId="478"/>
          <ac:spMkLst>
            <pc:docMk/>
            <pc:sldMk cId="236126241" sldId="257"/>
            <ac:spMk id="11" creationId="{7E5B1FD5-4AF1-8B64-E37E-814844183295}"/>
          </ac:spMkLst>
        </pc:spChg>
        <pc:spChg chg="del mod">
          <ac:chgData name="JUAN MANUEL LOZANO GIL" userId="618ed11e-cb2c-4b03-8ac9-a8cf52f924c9" providerId="ADAL" clId="{FD4A8C83-4AE1-46D4-B514-BCBE5E5C1962}" dt="2023-07-19T13:37:52.930" v="47" actId="478"/>
          <ac:spMkLst>
            <pc:docMk/>
            <pc:sldMk cId="236126241" sldId="257"/>
            <ac:spMk id="12" creationId="{03FF876E-8C70-EDE0-047E-831FE8D2F68F}"/>
          </ac:spMkLst>
        </pc:spChg>
        <pc:spChg chg="mod">
          <ac:chgData name="JUAN MANUEL LOZANO GIL" userId="618ed11e-cb2c-4b03-8ac9-a8cf52f924c9" providerId="ADAL" clId="{FD4A8C83-4AE1-46D4-B514-BCBE5E5C1962}" dt="2023-07-19T13:50:16.650" v="248" actId="1036"/>
          <ac:spMkLst>
            <pc:docMk/>
            <pc:sldMk cId="236126241" sldId="257"/>
            <ac:spMk id="29" creationId="{2135E244-1F3B-7BF0-3F61-E9745CC66162}"/>
          </ac:spMkLst>
        </pc:spChg>
        <pc:spChg chg="mod ord">
          <ac:chgData name="JUAN MANUEL LOZANO GIL" userId="618ed11e-cb2c-4b03-8ac9-a8cf52f924c9" providerId="ADAL" clId="{FD4A8C83-4AE1-46D4-B514-BCBE5E5C1962}" dt="2023-07-19T13:50:16.650" v="248" actId="1036"/>
          <ac:spMkLst>
            <pc:docMk/>
            <pc:sldMk cId="236126241" sldId="257"/>
            <ac:spMk id="30" creationId="{E74161A8-0EA0-0E29-6DB3-12E4B8BA11B5}"/>
          </ac:spMkLst>
        </pc:spChg>
        <pc:spChg chg="add mod">
          <ac:chgData name="JUAN MANUEL LOZANO GIL" userId="618ed11e-cb2c-4b03-8ac9-a8cf52f924c9" providerId="ADAL" clId="{FD4A8C83-4AE1-46D4-B514-BCBE5E5C1962}" dt="2023-07-19T13:50:16.650" v="248" actId="1036"/>
          <ac:spMkLst>
            <pc:docMk/>
            <pc:sldMk cId="236126241" sldId="257"/>
            <ac:spMk id="33" creationId="{E84F3B63-AEA0-463A-26D3-86C8A9B02E3E}"/>
          </ac:spMkLst>
        </pc:spChg>
        <pc:spChg chg="mod">
          <ac:chgData name="JUAN MANUEL LOZANO GIL" userId="618ed11e-cb2c-4b03-8ac9-a8cf52f924c9" providerId="ADAL" clId="{FD4A8C83-4AE1-46D4-B514-BCBE5E5C1962}" dt="2023-07-19T13:43:58.470" v="123"/>
          <ac:spMkLst>
            <pc:docMk/>
            <pc:sldMk cId="236126241" sldId="257"/>
            <ac:spMk id="36" creationId="{DAABA48B-B2B3-BBEC-3ACC-764D180C2708}"/>
          </ac:spMkLst>
        </pc:spChg>
        <pc:spChg chg="mod">
          <ac:chgData name="JUAN MANUEL LOZANO GIL" userId="618ed11e-cb2c-4b03-8ac9-a8cf52f924c9" providerId="ADAL" clId="{FD4A8C83-4AE1-46D4-B514-BCBE5E5C1962}" dt="2023-07-19T13:43:58.470" v="123"/>
          <ac:spMkLst>
            <pc:docMk/>
            <pc:sldMk cId="236126241" sldId="257"/>
            <ac:spMk id="41" creationId="{5EC7EF27-1BCF-FC91-4135-696DD1E00414}"/>
          </ac:spMkLst>
        </pc:spChg>
        <pc:spChg chg="mod">
          <ac:chgData name="JUAN MANUEL LOZANO GIL" userId="618ed11e-cb2c-4b03-8ac9-a8cf52f924c9" providerId="ADAL" clId="{FD4A8C83-4AE1-46D4-B514-BCBE5E5C1962}" dt="2023-07-19T13:43:58.470" v="123"/>
          <ac:spMkLst>
            <pc:docMk/>
            <pc:sldMk cId="236126241" sldId="257"/>
            <ac:spMk id="42" creationId="{D3F7CDF9-2D08-35FE-534A-018A37B597EB}"/>
          </ac:spMkLst>
        </pc:spChg>
        <pc:spChg chg="del">
          <ac:chgData name="JUAN MANUEL LOZANO GIL" userId="618ed11e-cb2c-4b03-8ac9-a8cf52f924c9" providerId="ADAL" clId="{FD4A8C83-4AE1-46D4-B514-BCBE5E5C1962}" dt="2023-07-19T13:35:59.090" v="16" actId="478"/>
          <ac:spMkLst>
            <pc:docMk/>
            <pc:sldMk cId="236126241" sldId="257"/>
            <ac:spMk id="44" creationId="{E7F871D1-DD2C-1CDC-89C0-9E1267696010}"/>
          </ac:spMkLst>
        </pc:spChg>
        <pc:spChg chg="del mod">
          <ac:chgData name="JUAN MANUEL LOZANO GIL" userId="618ed11e-cb2c-4b03-8ac9-a8cf52f924c9" providerId="ADAL" clId="{FD4A8C83-4AE1-46D4-B514-BCBE5E5C1962}" dt="2023-07-19T13:38:27.786" v="55" actId="478"/>
          <ac:spMkLst>
            <pc:docMk/>
            <pc:sldMk cId="236126241" sldId="257"/>
            <ac:spMk id="58" creationId="{43A1FED4-B30E-3905-0EF1-17DA44FC7FB8}"/>
          </ac:spMkLst>
        </pc:spChg>
        <pc:spChg chg="mod">
          <ac:chgData name="JUAN MANUEL LOZANO GIL" userId="618ed11e-cb2c-4b03-8ac9-a8cf52f924c9" providerId="ADAL" clId="{FD4A8C83-4AE1-46D4-B514-BCBE5E5C1962}" dt="2023-07-19T13:50:16.650" v="248" actId="1036"/>
          <ac:spMkLst>
            <pc:docMk/>
            <pc:sldMk cId="236126241" sldId="257"/>
            <ac:spMk id="59" creationId="{A473DF37-5308-B1AF-C511-0D15B7EE8B94}"/>
          </ac:spMkLst>
        </pc:spChg>
        <pc:spChg chg="del">
          <ac:chgData name="JUAN MANUEL LOZANO GIL" userId="618ed11e-cb2c-4b03-8ac9-a8cf52f924c9" providerId="ADAL" clId="{FD4A8C83-4AE1-46D4-B514-BCBE5E5C1962}" dt="2023-07-19T13:35:22.549" v="0" actId="478"/>
          <ac:spMkLst>
            <pc:docMk/>
            <pc:sldMk cId="236126241" sldId="257"/>
            <ac:spMk id="79" creationId="{A9EBDE9A-BBBC-92B4-5028-2898417ACC40}"/>
          </ac:spMkLst>
        </pc:spChg>
        <pc:spChg chg="mod">
          <ac:chgData name="JUAN MANUEL LOZANO GIL" userId="618ed11e-cb2c-4b03-8ac9-a8cf52f924c9" providerId="ADAL" clId="{FD4A8C83-4AE1-46D4-B514-BCBE5E5C1962}" dt="2023-07-19T13:44:49.245" v="134"/>
          <ac:spMkLst>
            <pc:docMk/>
            <pc:sldMk cId="236126241" sldId="257"/>
            <ac:spMk id="83" creationId="{3F804669-B2D2-40E0-3234-126D2340E4EA}"/>
          </ac:spMkLst>
        </pc:spChg>
        <pc:spChg chg="mod">
          <ac:chgData name="JUAN MANUEL LOZANO GIL" userId="618ed11e-cb2c-4b03-8ac9-a8cf52f924c9" providerId="ADAL" clId="{FD4A8C83-4AE1-46D4-B514-BCBE5E5C1962}" dt="2023-07-19T13:44:49.245" v="134"/>
          <ac:spMkLst>
            <pc:docMk/>
            <pc:sldMk cId="236126241" sldId="257"/>
            <ac:spMk id="84" creationId="{B13C7076-D656-FDEA-9EB7-258D7CAE4647}"/>
          </ac:spMkLst>
        </pc:spChg>
        <pc:spChg chg="mod">
          <ac:chgData name="JUAN MANUEL LOZANO GIL" userId="618ed11e-cb2c-4b03-8ac9-a8cf52f924c9" providerId="ADAL" clId="{FD4A8C83-4AE1-46D4-B514-BCBE5E5C1962}" dt="2023-07-19T13:44:49.245" v="134"/>
          <ac:spMkLst>
            <pc:docMk/>
            <pc:sldMk cId="236126241" sldId="257"/>
            <ac:spMk id="85" creationId="{448BA4DF-C99D-4F67-0220-62F111FE6C43}"/>
          </ac:spMkLst>
        </pc:spChg>
        <pc:spChg chg="mod">
          <ac:chgData name="JUAN MANUEL LOZANO GIL" userId="618ed11e-cb2c-4b03-8ac9-a8cf52f924c9" providerId="ADAL" clId="{FD4A8C83-4AE1-46D4-B514-BCBE5E5C1962}" dt="2023-07-19T13:44:49.245" v="134"/>
          <ac:spMkLst>
            <pc:docMk/>
            <pc:sldMk cId="236126241" sldId="257"/>
            <ac:spMk id="86" creationId="{BBF0D648-66C5-B5A9-ACC0-C85374772E5A}"/>
          </ac:spMkLst>
        </pc:spChg>
        <pc:spChg chg="add mod">
          <ac:chgData name="JUAN MANUEL LOZANO GIL" userId="618ed11e-cb2c-4b03-8ac9-a8cf52f924c9" providerId="ADAL" clId="{FD4A8C83-4AE1-46D4-B514-BCBE5E5C1962}" dt="2023-07-19T13:48:10.113" v="187" actId="1036"/>
          <ac:spMkLst>
            <pc:docMk/>
            <pc:sldMk cId="236126241" sldId="257"/>
            <ac:spMk id="91" creationId="{24414E85-2A5D-D8FA-1C6C-BFC9A7224972}"/>
          </ac:spMkLst>
        </pc:spChg>
        <pc:spChg chg="add mod">
          <ac:chgData name="JUAN MANUEL LOZANO GIL" userId="618ed11e-cb2c-4b03-8ac9-a8cf52f924c9" providerId="ADAL" clId="{FD4A8C83-4AE1-46D4-B514-BCBE5E5C1962}" dt="2023-07-19T13:50:16.650" v="248" actId="1036"/>
          <ac:spMkLst>
            <pc:docMk/>
            <pc:sldMk cId="236126241" sldId="257"/>
            <ac:spMk id="92" creationId="{AFA1D7EA-9ED5-0626-47B4-54BE33663C48}"/>
          </ac:spMkLst>
        </pc:spChg>
        <pc:spChg chg="add mod">
          <ac:chgData name="JUAN MANUEL LOZANO GIL" userId="618ed11e-cb2c-4b03-8ac9-a8cf52f924c9" providerId="ADAL" clId="{FD4A8C83-4AE1-46D4-B514-BCBE5E5C1962}" dt="2023-07-19T13:50:16.650" v="248" actId="1036"/>
          <ac:spMkLst>
            <pc:docMk/>
            <pc:sldMk cId="236126241" sldId="257"/>
            <ac:spMk id="93" creationId="{88C948C3-E068-7CC6-0930-663F68B23AA9}"/>
          </ac:spMkLst>
        </pc:spChg>
        <pc:spChg chg="del">
          <ac:chgData name="JUAN MANUEL LOZANO GIL" userId="618ed11e-cb2c-4b03-8ac9-a8cf52f924c9" providerId="ADAL" clId="{FD4A8C83-4AE1-46D4-B514-BCBE5E5C1962}" dt="2023-07-19T13:35:22.549" v="0" actId="478"/>
          <ac:spMkLst>
            <pc:docMk/>
            <pc:sldMk cId="236126241" sldId="257"/>
            <ac:spMk id="111" creationId="{639D055B-F362-C4D7-03B5-C623AAFF4CA5}"/>
          </ac:spMkLst>
        </pc:spChg>
        <pc:spChg chg="del">
          <ac:chgData name="JUAN MANUEL LOZANO GIL" userId="618ed11e-cb2c-4b03-8ac9-a8cf52f924c9" providerId="ADAL" clId="{FD4A8C83-4AE1-46D4-B514-BCBE5E5C1962}" dt="2023-07-19T13:35:22.549" v="0" actId="478"/>
          <ac:spMkLst>
            <pc:docMk/>
            <pc:sldMk cId="236126241" sldId="257"/>
            <ac:spMk id="112" creationId="{17DE7CD4-CEF5-1A3C-4405-DC9E90863427}"/>
          </ac:spMkLst>
        </pc:spChg>
        <pc:spChg chg="del">
          <ac:chgData name="JUAN MANUEL LOZANO GIL" userId="618ed11e-cb2c-4b03-8ac9-a8cf52f924c9" providerId="ADAL" clId="{FD4A8C83-4AE1-46D4-B514-BCBE5E5C1962}" dt="2023-07-19T13:35:22.549" v="0" actId="478"/>
          <ac:spMkLst>
            <pc:docMk/>
            <pc:sldMk cId="236126241" sldId="257"/>
            <ac:spMk id="113" creationId="{B9F64BC0-143F-F0DC-D338-6209797FBA4D}"/>
          </ac:spMkLst>
        </pc:spChg>
        <pc:spChg chg="add mod">
          <ac:chgData name="JUAN MANUEL LOZANO GIL" userId="618ed11e-cb2c-4b03-8ac9-a8cf52f924c9" providerId="ADAL" clId="{FD4A8C83-4AE1-46D4-B514-BCBE5E5C1962}" dt="2023-07-19T13:48:10.113" v="187" actId="1036"/>
          <ac:spMkLst>
            <pc:docMk/>
            <pc:sldMk cId="236126241" sldId="257"/>
            <ac:spMk id="114" creationId="{5E095BFE-D42C-9B6C-5AE5-3D9EF0E78916}"/>
          </ac:spMkLst>
        </pc:spChg>
        <pc:spChg chg="del">
          <ac:chgData name="JUAN MANUEL LOZANO GIL" userId="618ed11e-cb2c-4b03-8ac9-a8cf52f924c9" providerId="ADAL" clId="{FD4A8C83-4AE1-46D4-B514-BCBE5E5C1962}" dt="2023-07-19T13:35:22.549" v="0" actId="478"/>
          <ac:spMkLst>
            <pc:docMk/>
            <pc:sldMk cId="236126241" sldId="257"/>
            <ac:spMk id="115" creationId="{E793D70F-9D4F-DC80-0EF0-00F9547C648D}"/>
          </ac:spMkLst>
        </pc:spChg>
        <pc:spChg chg="add mod">
          <ac:chgData name="JUAN MANUEL LOZANO GIL" userId="618ed11e-cb2c-4b03-8ac9-a8cf52f924c9" providerId="ADAL" clId="{FD4A8C83-4AE1-46D4-B514-BCBE5E5C1962}" dt="2023-07-19T13:48:21.145" v="199" actId="20577"/>
          <ac:spMkLst>
            <pc:docMk/>
            <pc:sldMk cId="236126241" sldId="257"/>
            <ac:spMk id="117" creationId="{19C9CD12-D77B-70BA-40F5-B629030DB72D}"/>
          </ac:spMkLst>
        </pc:spChg>
        <pc:spChg chg="add mod">
          <ac:chgData name="JUAN MANUEL LOZANO GIL" userId="618ed11e-cb2c-4b03-8ac9-a8cf52f924c9" providerId="ADAL" clId="{FD4A8C83-4AE1-46D4-B514-BCBE5E5C1962}" dt="2023-07-19T13:48:32.138" v="201" actId="1076"/>
          <ac:spMkLst>
            <pc:docMk/>
            <pc:sldMk cId="236126241" sldId="257"/>
            <ac:spMk id="118" creationId="{EF6C184F-7B1C-A70B-29EA-596902D3C766}"/>
          </ac:spMkLst>
        </pc:spChg>
        <pc:spChg chg="mod">
          <ac:chgData name="JUAN MANUEL LOZANO GIL" userId="618ed11e-cb2c-4b03-8ac9-a8cf52f924c9" providerId="ADAL" clId="{FD4A8C83-4AE1-46D4-B514-BCBE5E5C1962}" dt="2023-07-19T13:48:35.317" v="202"/>
          <ac:spMkLst>
            <pc:docMk/>
            <pc:sldMk cId="236126241" sldId="257"/>
            <ac:spMk id="128" creationId="{74BA32B5-B0A9-0AEC-37CD-FC05BAB098E4}"/>
          </ac:spMkLst>
        </pc:spChg>
        <pc:spChg chg="mod">
          <ac:chgData name="JUAN MANUEL LOZANO GIL" userId="618ed11e-cb2c-4b03-8ac9-a8cf52f924c9" providerId="ADAL" clId="{FD4A8C83-4AE1-46D4-B514-BCBE5E5C1962}" dt="2023-07-19T13:48:35.317" v="202"/>
          <ac:spMkLst>
            <pc:docMk/>
            <pc:sldMk cId="236126241" sldId="257"/>
            <ac:spMk id="129" creationId="{08CEBB25-A2E1-AA7D-31FC-F85DE589D177}"/>
          </ac:spMkLst>
        </pc:spChg>
        <pc:spChg chg="mod">
          <ac:chgData name="JUAN MANUEL LOZANO GIL" userId="618ed11e-cb2c-4b03-8ac9-a8cf52f924c9" providerId="ADAL" clId="{FD4A8C83-4AE1-46D4-B514-BCBE5E5C1962}" dt="2023-07-19T13:48:35.317" v="202"/>
          <ac:spMkLst>
            <pc:docMk/>
            <pc:sldMk cId="236126241" sldId="257"/>
            <ac:spMk id="135" creationId="{FD223CEE-86C8-A1D9-CEBB-425AB0DBC5F4}"/>
          </ac:spMkLst>
        </pc:spChg>
        <pc:spChg chg="mod">
          <ac:chgData name="JUAN MANUEL LOZANO GIL" userId="618ed11e-cb2c-4b03-8ac9-a8cf52f924c9" providerId="ADAL" clId="{FD4A8C83-4AE1-46D4-B514-BCBE5E5C1962}" dt="2023-07-19T13:48:35.317" v="202"/>
          <ac:spMkLst>
            <pc:docMk/>
            <pc:sldMk cId="236126241" sldId="257"/>
            <ac:spMk id="136" creationId="{79F4EA5C-A008-5DD9-B7FC-4484DC876F38}"/>
          </ac:spMkLst>
        </pc:spChg>
        <pc:spChg chg="del">
          <ac:chgData name="JUAN MANUEL LOZANO GIL" userId="618ed11e-cb2c-4b03-8ac9-a8cf52f924c9" providerId="ADAL" clId="{FD4A8C83-4AE1-46D4-B514-BCBE5E5C1962}" dt="2023-07-19T13:35:22.549" v="0" actId="478"/>
          <ac:spMkLst>
            <pc:docMk/>
            <pc:sldMk cId="236126241" sldId="257"/>
            <ac:spMk id="137" creationId="{132FFF07-291A-65D4-EBB7-545D316F222E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2" creationId="{A40CF989-C138-F77D-3189-BD21913B6001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3" creationId="{0A3D6041-80D0-8D0B-75FB-DAD76E1D4805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4" creationId="{E3297731-C514-D354-E777-8E7EE4FAF985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5" creationId="{5283C870-8DA9-5BD6-9E7D-7316A647CBDB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6" creationId="{96C288B5-24CC-5C07-9217-9888DD8C1D46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7" creationId="{F297169B-F513-3CF2-5F88-D72B22719648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8" creationId="{5C099CCE-BA5E-23CF-F3B7-A094B26A9EF9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49" creationId="{B346BB3D-B891-2B5A-C301-74B6E309FACF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0" creationId="{FE5CA787-A2E1-9CEA-FCF1-86C2DEA5180E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1" creationId="{EE5C7A38-6604-47C5-2D97-90AE89CD35CF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2" creationId="{68DC86E3-5457-80B1-2818-9CC69D094395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3" creationId="{58491170-84EA-56BA-0AC1-2A1BD29A3C62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4" creationId="{EC6A44D4-5318-8F7B-0423-B17231012609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5" creationId="{4025E247-E80D-AB85-E100-2E062BC744C2}"/>
          </ac:spMkLst>
        </pc:spChg>
        <pc:spChg chg="add mod">
          <ac:chgData name="JUAN MANUEL LOZANO GIL" userId="618ed11e-cb2c-4b03-8ac9-a8cf52f924c9" providerId="ADAL" clId="{FD4A8C83-4AE1-46D4-B514-BCBE5E5C1962}" dt="2023-07-19T13:49:56.364" v="226" actId="1035"/>
          <ac:spMkLst>
            <pc:docMk/>
            <pc:sldMk cId="236126241" sldId="257"/>
            <ac:spMk id="156" creationId="{8D48CC7F-9ABE-9322-59A8-67605DC26AA3}"/>
          </ac:spMkLst>
        </pc:spChg>
        <pc:spChg chg="add mod">
          <ac:chgData name="JUAN MANUEL LOZANO GIL" userId="618ed11e-cb2c-4b03-8ac9-a8cf52f924c9" providerId="ADAL" clId="{FD4A8C83-4AE1-46D4-B514-BCBE5E5C1962}" dt="2023-07-19T13:49:52.964" v="223" actId="1035"/>
          <ac:spMkLst>
            <pc:docMk/>
            <pc:sldMk cId="236126241" sldId="257"/>
            <ac:spMk id="157" creationId="{07C08688-4E2D-A160-0CDD-D630CA559D82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8" creationId="{7215107A-E6E1-FBC6-B80C-55FED8CD8B6F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59" creationId="{124F2B2F-DE2C-6373-E37B-2D89FCD7DCA9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60" creationId="{6B09E8BC-874D-1866-D6A8-C6D8F01FB8D0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61" creationId="{8A126945-EFB3-D54C-0755-A9F723D78F48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62" creationId="{AE6BF758-8AAC-2D47-71B4-091926132D64}"/>
          </ac:spMkLst>
        </pc:spChg>
        <pc:spChg chg="add mod">
          <ac:chgData name="JUAN MANUEL LOZANO GIL" userId="618ed11e-cb2c-4b03-8ac9-a8cf52f924c9" providerId="ADAL" clId="{FD4A8C83-4AE1-46D4-B514-BCBE5E5C1962}" dt="2023-07-19T13:49:49.039" v="219" actId="404"/>
          <ac:spMkLst>
            <pc:docMk/>
            <pc:sldMk cId="236126241" sldId="257"/>
            <ac:spMk id="163" creationId="{231DC0A2-2B61-2A21-9756-2AC2AC9E2B0E}"/>
          </ac:spMkLst>
        </pc:spChg>
        <pc:grpChg chg="mod">
          <ac:chgData name="JUAN MANUEL LOZANO GIL" userId="618ed11e-cb2c-4b03-8ac9-a8cf52f924c9" providerId="ADAL" clId="{FD4A8C83-4AE1-46D4-B514-BCBE5E5C1962}" dt="2023-07-19T13:50:16.650" v="248" actId="1036"/>
          <ac:grpSpMkLst>
            <pc:docMk/>
            <pc:sldMk cId="236126241" sldId="257"/>
            <ac:grpSpMk id="6" creationId="{80952FC4-A08B-B3D7-D07B-CE6C844A14A9}"/>
          </ac:grpSpMkLst>
        </pc:grpChg>
        <pc:grpChg chg="mod">
          <ac:chgData name="JUAN MANUEL LOZANO GIL" userId="618ed11e-cb2c-4b03-8ac9-a8cf52f924c9" providerId="ADAL" clId="{FD4A8C83-4AE1-46D4-B514-BCBE5E5C1962}" dt="2023-07-19T13:50:16.650" v="248" actId="1036"/>
          <ac:grpSpMkLst>
            <pc:docMk/>
            <pc:sldMk cId="236126241" sldId="257"/>
            <ac:grpSpMk id="8" creationId="{6ECEC6D2-B89B-EC32-D2E5-16233731C6B3}"/>
          </ac:grpSpMkLst>
        </pc:grpChg>
        <pc:grpChg chg="add mod">
          <ac:chgData name="JUAN MANUEL LOZANO GIL" userId="618ed11e-cb2c-4b03-8ac9-a8cf52f924c9" providerId="ADAL" clId="{FD4A8C83-4AE1-46D4-B514-BCBE5E5C1962}" dt="2023-07-19T13:50:16.650" v="248" actId="1036"/>
          <ac:grpSpMkLst>
            <pc:docMk/>
            <pc:sldMk cId="236126241" sldId="257"/>
            <ac:grpSpMk id="34" creationId="{B979160C-197B-6B2D-A99B-1BCF502DDA93}"/>
          </ac:grpSpMkLst>
        </pc:grpChg>
        <pc:grpChg chg="mod">
          <ac:chgData name="JUAN MANUEL LOZANO GIL" userId="618ed11e-cb2c-4b03-8ac9-a8cf52f924c9" providerId="ADAL" clId="{FD4A8C83-4AE1-46D4-B514-BCBE5E5C1962}" dt="2023-07-19T13:43:58.470" v="123"/>
          <ac:grpSpMkLst>
            <pc:docMk/>
            <pc:sldMk cId="236126241" sldId="257"/>
            <ac:grpSpMk id="35" creationId="{95F63A75-BD18-74D5-E9DD-FE2E63AAE768}"/>
          </ac:grpSpMkLst>
        </pc:grpChg>
        <pc:grpChg chg="del">
          <ac:chgData name="JUAN MANUEL LOZANO GIL" userId="618ed11e-cb2c-4b03-8ac9-a8cf52f924c9" providerId="ADAL" clId="{FD4A8C83-4AE1-46D4-B514-BCBE5E5C1962}" dt="2023-07-19T13:35:29.491" v="3" actId="478"/>
          <ac:grpSpMkLst>
            <pc:docMk/>
            <pc:sldMk cId="236126241" sldId="257"/>
            <ac:grpSpMk id="55" creationId="{310D0092-15C0-5BAC-78B3-2FF9B3258CF6}"/>
          </ac:grpSpMkLst>
        </pc:grpChg>
        <pc:grpChg chg="del">
          <ac:chgData name="JUAN MANUEL LOZANO GIL" userId="618ed11e-cb2c-4b03-8ac9-a8cf52f924c9" providerId="ADAL" clId="{FD4A8C83-4AE1-46D4-B514-BCBE5E5C1962}" dt="2023-07-19T13:35:22.549" v="0" actId="478"/>
          <ac:grpSpMkLst>
            <pc:docMk/>
            <pc:sldMk cId="236126241" sldId="257"/>
            <ac:grpSpMk id="63" creationId="{B51C5646-7A41-6ABE-0BD8-D3D0365DF8F3}"/>
          </ac:grpSpMkLst>
        </pc:grpChg>
        <pc:grpChg chg="add mod">
          <ac:chgData name="JUAN MANUEL LOZANO GIL" userId="618ed11e-cb2c-4b03-8ac9-a8cf52f924c9" providerId="ADAL" clId="{FD4A8C83-4AE1-46D4-B514-BCBE5E5C1962}" dt="2023-07-19T13:48:10.113" v="187" actId="1036"/>
          <ac:grpSpMkLst>
            <pc:docMk/>
            <pc:sldMk cId="236126241" sldId="257"/>
            <ac:grpSpMk id="81" creationId="{640AE604-F08C-9D15-EE5E-6E29F7C127F2}"/>
          </ac:grpSpMkLst>
        </pc:grpChg>
        <pc:grpChg chg="mod">
          <ac:chgData name="JUAN MANUEL LOZANO GIL" userId="618ed11e-cb2c-4b03-8ac9-a8cf52f924c9" providerId="ADAL" clId="{FD4A8C83-4AE1-46D4-B514-BCBE5E5C1962}" dt="2023-07-19T13:44:49.245" v="134"/>
          <ac:grpSpMkLst>
            <pc:docMk/>
            <pc:sldMk cId="236126241" sldId="257"/>
            <ac:grpSpMk id="82" creationId="{319FE988-8403-4E2E-D344-EEF3DDD9691A}"/>
          </ac:grpSpMkLst>
        </pc:grpChg>
        <pc:grpChg chg="del">
          <ac:chgData name="JUAN MANUEL LOZANO GIL" userId="618ed11e-cb2c-4b03-8ac9-a8cf52f924c9" providerId="ADAL" clId="{FD4A8C83-4AE1-46D4-B514-BCBE5E5C1962}" dt="2023-07-19T13:35:22.549" v="0" actId="478"/>
          <ac:grpSpMkLst>
            <pc:docMk/>
            <pc:sldMk cId="236126241" sldId="257"/>
            <ac:grpSpMk id="95" creationId="{9A88576D-03BD-A42B-E63C-E85294663A8C}"/>
          </ac:grpSpMkLst>
        </pc:grpChg>
        <pc:grpChg chg="add mod">
          <ac:chgData name="JUAN MANUEL LOZANO GIL" userId="618ed11e-cb2c-4b03-8ac9-a8cf52f924c9" providerId="ADAL" clId="{FD4A8C83-4AE1-46D4-B514-BCBE5E5C1962}" dt="2023-07-19T13:48:41.611" v="205" actId="1036"/>
          <ac:grpSpMkLst>
            <pc:docMk/>
            <pc:sldMk cId="236126241" sldId="257"/>
            <ac:grpSpMk id="119" creationId="{F3614D40-211B-DE66-01C2-02D248374FEA}"/>
          </ac:grpSpMkLst>
        </pc:grpChg>
        <pc:grpChg chg="mod">
          <ac:chgData name="JUAN MANUEL LOZANO GIL" userId="618ed11e-cb2c-4b03-8ac9-a8cf52f924c9" providerId="ADAL" clId="{FD4A8C83-4AE1-46D4-B514-BCBE5E5C1962}" dt="2023-07-19T13:48:35.317" v="202"/>
          <ac:grpSpMkLst>
            <pc:docMk/>
            <pc:sldMk cId="236126241" sldId="257"/>
            <ac:grpSpMk id="120" creationId="{29CFB9FB-ADDB-DA58-2BD4-5784A2C24CC8}"/>
          </ac:grpSpMkLst>
        </pc:grpChg>
        <pc:grpChg chg="del">
          <ac:chgData name="JUAN MANUEL LOZANO GIL" userId="618ed11e-cb2c-4b03-8ac9-a8cf52f924c9" providerId="ADAL" clId="{FD4A8C83-4AE1-46D4-B514-BCBE5E5C1962}" dt="2023-07-19T13:35:22.549" v="0" actId="478"/>
          <ac:grpSpMkLst>
            <pc:docMk/>
            <pc:sldMk cId="236126241" sldId="257"/>
            <ac:grpSpMk id="121" creationId="{F7DD65EB-E362-A17D-3E97-08606792C1C6}"/>
          </ac:grpSpMkLst>
        </pc:grpChg>
        <pc:grpChg chg="add mod">
          <ac:chgData name="JUAN MANUEL LOZANO GIL" userId="618ed11e-cb2c-4b03-8ac9-a8cf52f924c9" providerId="ADAL" clId="{FD4A8C83-4AE1-46D4-B514-BCBE5E5C1962}" dt="2023-07-19T13:50:16.650" v="248" actId="1036"/>
          <ac:grpSpMkLst>
            <pc:docMk/>
            <pc:sldMk cId="236126241" sldId="257"/>
            <ac:grpSpMk id="164" creationId="{FEB60033-D526-8364-38B3-CFFDBC867A43}"/>
          </ac:grpSpMkLst>
        </pc:grpChg>
        <pc:picChg chg="del">
          <ac:chgData name="JUAN MANUEL LOZANO GIL" userId="618ed11e-cb2c-4b03-8ac9-a8cf52f924c9" providerId="ADAL" clId="{FD4A8C83-4AE1-46D4-B514-BCBE5E5C1962}" dt="2023-07-19T13:35:22.549" v="0" actId="478"/>
          <ac:picMkLst>
            <pc:docMk/>
            <pc:sldMk cId="236126241" sldId="257"/>
            <ac:picMk id="2" creationId="{BCB759F8-6631-5AC7-169B-46143ED698D1}"/>
          </ac:picMkLst>
        </pc:picChg>
        <pc:picChg chg="del">
          <ac:chgData name="JUAN MANUEL LOZANO GIL" userId="618ed11e-cb2c-4b03-8ac9-a8cf52f924c9" providerId="ADAL" clId="{FD4A8C83-4AE1-46D4-B514-BCBE5E5C1962}" dt="2023-07-19T13:35:24.665" v="2" actId="478"/>
          <ac:picMkLst>
            <pc:docMk/>
            <pc:sldMk cId="236126241" sldId="257"/>
            <ac:picMk id="3" creationId="{42A409BF-BF62-2408-5370-A1AC57EDC83F}"/>
          </ac:picMkLst>
        </pc:picChg>
        <pc:picChg chg="add mod modCrop">
          <ac:chgData name="JUAN MANUEL LOZANO GIL" userId="618ed11e-cb2c-4b03-8ac9-a8cf52f924c9" providerId="ADAL" clId="{FD4A8C83-4AE1-46D4-B514-BCBE5E5C1962}" dt="2023-07-19T13:50:16.650" v="248" actId="1036"/>
          <ac:picMkLst>
            <pc:docMk/>
            <pc:sldMk cId="236126241" sldId="257"/>
            <ac:picMk id="5" creationId="{B9A29602-3B2B-DD44-D8BE-6CEB0AD04257}"/>
          </ac:picMkLst>
        </pc:picChg>
        <pc:picChg chg="add mod modCrop">
          <ac:chgData name="JUAN MANUEL LOZANO GIL" userId="618ed11e-cb2c-4b03-8ac9-a8cf52f924c9" providerId="ADAL" clId="{FD4A8C83-4AE1-46D4-B514-BCBE5E5C1962}" dt="2023-07-19T13:50:16.650" v="248" actId="1036"/>
          <ac:picMkLst>
            <pc:docMk/>
            <pc:sldMk cId="236126241" sldId="257"/>
            <ac:picMk id="28" creationId="{8AD8BB02-6E84-B20D-CFA5-45CB8888B766}"/>
          </ac:picMkLst>
        </pc:picChg>
        <pc:picChg chg="add mod modCrop">
          <ac:chgData name="JUAN MANUEL LOZANO GIL" userId="618ed11e-cb2c-4b03-8ac9-a8cf52f924c9" providerId="ADAL" clId="{FD4A8C83-4AE1-46D4-B514-BCBE5E5C1962}" dt="2023-07-19T13:50:16.650" v="248" actId="1036"/>
          <ac:picMkLst>
            <pc:docMk/>
            <pc:sldMk cId="236126241" sldId="257"/>
            <ac:picMk id="32" creationId="{1792F7B4-0C44-48D8-B046-B044722301FF}"/>
          </ac:picMkLst>
        </pc:picChg>
        <pc:picChg chg="del">
          <ac:chgData name="JUAN MANUEL LOZANO GIL" userId="618ed11e-cb2c-4b03-8ac9-a8cf52f924c9" providerId="ADAL" clId="{FD4A8C83-4AE1-46D4-B514-BCBE5E5C1962}" dt="2023-07-19T13:35:23.475" v="1" actId="478"/>
          <ac:picMkLst>
            <pc:docMk/>
            <pc:sldMk cId="236126241" sldId="257"/>
            <ac:picMk id="57" creationId="{1219A44C-029A-7585-8F53-35D405D37E24}"/>
          </ac:picMkLst>
        </pc:picChg>
        <pc:picChg chg="del">
          <ac:chgData name="JUAN MANUEL LOZANO GIL" userId="618ed11e-cb2c-4b03-8ac9-a8cf52f924c9" providerId="ADAL" clId="{FD4A8C83-4AE1-46D4-B514-BCBE5E5C1962}" dt="2023-07-19T13:35:22.549" v="0" actId="478"/>
          <ac:picMkLst>
            <pc:docMk/>
            <pc:sldMk cId="236126241" sldId="257"/>
            <ac:picMk id="62" creationId="{F2141D81-4FA9-8618-E836-00E38748E7EF}"/>
          </ac:picMkLst>
        </pc:picChg>
        <pc:picChg chg="add mod modCrop">
          <ac:chgData name="JUAN MANUEL LOZANO GIL" userId="618ed11e-cb2c-4b03-8ac9-a8cf52f924c9" providerId="ADAL" clId="{FD4A8C83-4AE1-46D4-B514-BCBE5E5C1962}" dt="2023-07-19T13:48:10.113" v="187" actId="1036"/>
          <ac:picMkLst>
            <pc:docMk/>
            <pc:sldMk cId="236126241" sldId="257"/>
            <ac:picMk id="80" creationId="{ADB22CC1-C9F5-9A71-B0AA-4CFDCDABAB13}"/>
          </ac:picMkLst>
        </pc:picChg>
        <pc:picChg chg="del">
          <ac:chgData name="JUAN MANUEL LOZANO GIL" userId="618ed11e-cb2c-4b03-8ac9-a8cf52f924c9" providerId="ADAL" clId="{FD4A8C83-4AE1-46D4-B514-BCBE5E5C1962}" dt="2023-07-19T13:35:22.549" v="0" actId="478"/>
          <ac:picMkLst>
            <pc:docMk/>
            <pc:sldMk cId="236126241" sldId="257"/>
            <ac:picMk id="94" creationId="{430E5B00-1908-D489-1059-7458EC9A0E10}"/>
          </ac:picMkLst>
        </pc:picChg>
        <pc:picChg chg="add mod modCrop">
          <ac:chgData name="JUAN MANUEL LOZANO GIL" userId="618ed11e-cb2c-4b03-8ac9-a8cf52f924c9" providerId="ADAL" clId="{FD4A8C83-4AE1-46D4-B514-BCBE5E5C1962}" dt="2023-07-19T13:48:10.113" v="187" actId="1036"/>
          <ac:picMkLst>
            <pc:docMk/>
            <pc:sldMk cId="236126241" sldId="257"/>
            <ac:picMk id="116" creationId="{A3C6B447-1D1E-03E9-726A-2E73DD6DD744}"/>
          </ac:picMkLst>
        </pc:picChg>
        <pc:cxnChg chg="del">
          <ac:chgData name="JUAN MANUEL LOZANO GIL" userId="618ed11e-cb2c-4b03-8ac9-a8cf52f924c9" providerId="ADAL" clId="{FD4A8C83-4AE1-46D4-B514-BCBE5E5C1962}" dt="2023-07-19T13:38:11.459" v="52" actId="478"/>
          <ac:cxnSpMkLst>
            <pc:docMk/>
            <pc:sldMk cId="236126241" sldId="257"/>
            <ac:cxnSpMk id="19" creationId="{6832DE56-29C6-7D0D-9027-606FBE897E91}"/>
          </ac:cxnSpMkLst>
        </pc:cxnChg>
        <pc:cxnChg chg="del">
          <ac:chgData name="JUAN MANUEL LOZANO GIL" userId="618ed11e-cb2c-4b03-8ac9-a8cf52f924c9" providerId="ADAL" clId="{FD4A8C83-4AE1-46D4-B514-BCBE5E5C1962}" dt="2023-07-19T13:38:09.827" v="51" actId="478"/>
          <ac:cxnSpMkLst>
            <pc:docMk/>
            <pc:sldMk cId="236126241" sldId="257"/>
            <ac:cxnSpMk id="20" creationId="{4FC2D830-27B3-DC62-91D0-9648EFE398D0}"/>
          </ac:cxnSpMkLst>
        </pc:cxnChg>
        <pc:cxnChg chg="del">
          <ac:chgData name="JUAN MANUEL LOZANO GIL" userId="618ed11e-cb2c-4b03-8ac9-a8cf52f924c9" providerId="ADAL" clId="{FD4A8C83-4AE1-46D4-B514-BCBE5E5C1962}" dt="2023-07-19T13:37:51.331" v="45" actId="478"/>
          <ac:cxnSpMkLst>
            <pc:docMk/>
            <pc:sldMk cId="236126241" sldId="257"/>
            <ac:cxnSpMk id="21" creationId="{CB9017B7-481F-5B33-8B78-F133DF6C1884}"/>
          </ac:cxnSpMkLst>
        </pc:cxnChg>
        <pc:cxnChg chg="del">
          <ac:chgData name="JUAN MANUEL LOZANO GIL" userId="618ed11e-cb2c-4b03-8ac9-a8cf52f924c9" providerId="ADAL" clId="{FD4A8C83-4AE1-46D4-B514-BCBE5E5C1962}" dt="2023-07-19T13:36:07.266" v="22" actId="478"/>
          <ac:cxnSpMkLst>
            <pc:docMk/>
            <pc:sldMk cId="236126241" sldId="257"/>
            <ac:cxnSpMk id="40" creationId="{05F33000-8D74-1AD7-6444-941A53DB300E}"/>
          </ac:cxnSpMkLst>
        </pc:cxnChg>
        <pc:cxnChg chg="mod">
          <ac:chgData name="JUAN MANUEL LOZANO GIL" userId="618ed11e-cb2c-4b03-8ac9-a8cf52f924c9" providerId="ADAL" clId="{FD4A8C83-4AE1-46D4-B514-BCBE5E5C1962}" dt="2023-07-19T13:43:58.470" v="123"/>
          <ac:cxnSpMkLst>
            <pc:docMk/>
            <pc:sldMk cId="236126241" sldId="257"/>
            <ac:cxnSpMk id="43" creationId="{3EC6B81A-EC95-2D71-9A47-EA6936FE7CB5}"/>
          </ac:cxnSpMkLst>
        </pc:cxnChg>
        <pc:cxnChg chg="mod">
          <ac:chgData name="JUAN MANUEL LOZANO GIL" userId="618ed11e-cb2c-4b03-8ac9-a8cf52f924c9" providerId="ADAL" clId="{FD4A8C83-4AE1-46D4-B514-BCBE5E5C1962}" dt="2023-07-19T13:43:58.470" v="123"/>
          <ac:cxnSpMkLst>
            <pc:docMk/>
            <pc:sldMk cId="236126241" sldId="257"/>
            <ac:cxnSpMk id="56" creationId="{BFA666DC-BD86-0425-C9B8-FB10CCB1D056}"/>
          </ac:cxnSpMkLst>
        </pc:cxnChg>
        <pc:cxnChg chg="mod">
          <ac:chgData name="JUAN MANUEL LOZANO GIL" userId="618ed11e-cb2c-4b03-8ac9-a8cf52f924c9" providerId="ADAL" clId="{FD4A8C83-4AE1-46D4-B514-BCBE5E5C1962}" dt="2023-07-19T13:43:58.470" v="123"/>
          <ac:cxnSpMkLst>
            <pc:docMk/>
            <pc:sldMk cId="236126241" sldId="257"/>
            <ac:cxnSpMk id="60" creationId="{0D63E881-38F8-2ABE-0F80-DBBD87A280E6}"/>
          </ac:cxnSpMkLst>
        </pc:cxnChg>
        <pc:cxnChg chg="mod">
          <ac:chgData name="JUAN MANUEL LOZANO GIL" userId="618ed11e-cb2c-4b03-8ac9-a8cf52f924c9" providerId="ADAL" clId="{FD4A8C83-4AE1-46D4-B514-BCBE5E5C1962}" dt="2023-07-19T13:44:49.245" v="134"/>
          <ac:cxnSpMkLst>
            <pc:docMk/>
            <pc:sldMk cId="236126241" sldId="257"/>
            <ac:cxnSpMk id="87" creationId="{02E4A975-4F3C-0C6C-0608-4BFA90E85217}"/>
          </ac:cxnSpMkLst>
        </pc:cxnChg>
        <pc:cxnChg chg="mod">
          <ac:chgData name="JUAN MANUEL LOZANO GIL" userId="618ed11e-cb2c-4b03-8ac9-a8cf52f924c9" providerId="ADAL" clId="{FD4A8C83-4AE1-46D4-B514-BCBE5E5C1962}" dt="2023-07-19T13:44:49.245" v="134"/>
          <ac:cxnSpMkLst>
            <pc:docMk/>
            <pc:sldMk cId="236126241" sldId="257"/>
            <ac:cxnSpMk id="88" creationId="{49A77370-E557-A471-DE3C-2933F2F225C1}"/>
          </ac:cxnSpMkLst>
        </pc:cxnChg>
        <pc:cxnChg chg="mod">
          <ac:chgData name="JUAN MANUEL LOZANO GIL" userId="618ed11e-cb2c-4b03-8ac9-a8cf52f924c9" providerId="ADAL" clId="{FD4A8C83-4AE1-46D4-B514-BCBE5E5C1962}" dt="2023-07-19T13:44:49.245" v="134"/>
          <ac:cxnSpMkLst>
            <pc:docMk/>
            <pc:sldMk cId="236126241" sldId="257"/>
            <ac:cxnSpMk id="89" creationId="{B2268782-932F-64E4-5F48-97256AF5857E}"/>
          </ac:cxnSpMkLst>
        </pc:cxnChg>
        <pc:cxnChg chg="mod">
          <ac:chgData name="JUAN MANUEL LOZANO GIL" userId="618ed11e-cb2c-4b03-8ac9-a8cf52f924c9" providerId="ADAL" clId="{FD4A8C83-4AE1-46D4-B514-BCBE5E5C1962}" dt="2023-07-19T13:44:49.245" v="134"/>
          <ac:cxnSpMkLst>
            <pc:docMk/>
            <pc:sldMk cId="236126241" sldId="257"/>
            <ac:cxnSpMk id="90" creationId="{B09D455F-AC68-FA93-0F33-AFB61EF138F8}"/>
          </ac:cxnSpMkLst>
        </pc:cxnChg>
        <pc:cxnChg chg="mod">
          <ac:chgData name="JUAN MANUEL LOZANO GIL" userId="618ed11e-cb2c-4b03-8ac9-a8cf52f924c9" providerId="ADAL" clId="{FD4A8C83-4AE1-46D4-B514-BCBE5E5C1962}" dt="2023-07-19T13:48:35.317" v="202"/>
          <ac:cxnSpMkLst>
            <pc:docMk/>
            <pc:sldMk cId="236126241" sldId="257"/>
            <ac:cxnSpMk id="138" creationId="{D35EE359-AAAB-F17A-CB5F-9F84F3F51FF0}"/>
          </ac:cxnSpMkLst>
        </pc:cxnChg>
        <pc:cxnChg chg="mod">
          <ac:chgData name="JUAN MANUEL LOZANO GIL" userId="618ed11e-cb2c-4b03-8ac9-a8cf52f924c9" providerId="ADAL" clId="{FD4A8C83-4AE1-46D4-B514-BCBE5E5C1962}" dt="2023-07-19T13:48:35.317" v="202"/>
          <ac:cxnSpMkLst>
            <pc:docMk/>
            <pc:sldMk cId="236126241" sldId="257"/>
            <ac:cxnSpMk id="139" creationId="{D1A598F9-D6B1-B325-773C-2E5F0B9B7861}"/>
          </ac:cxnSpMkLst>
        </pc:cxnChg>
        <pc:cxnChg chg="mod">
          <ac:chgData name="JUAN MANUEL LOZANO GIL" userId="618ed11e-cb2c-4b03-8ac9-a8cf52f924c9" providerId="ADAL" clId="{FD4A8C83-4AE1-46D4-B514-BCBE5E5C1962}" dt="2023-07-19T13:48:35.317" v="202"/>
          <ac:cxnSpMkLst>
            <pc:docMk/>
            <pc:sldMk cId="236126241" sldId="257"/>
            <ac:cxnSpMk id="140" creationId="{23E0326B-925B-0C6A-1810-99B1E3431A07}"/>
          </ac:cxnSpMkLst>
        </pc:cxnChg>
        <pc:cxnChg chg="mod">
          <ac:chgData name="JUAN MANUEL LOZANO GIL" userId="618ed11e-cb2c-4b03-8ac9-a8cf52f924c9" providerId="ADAL" clId="{FD4A8C83-4AE1-46D4-B514-BCBE5E5C1962}" dt="2023-07-19T13:48:35.317" v="202"/>
          <ac:cxnSpMkLst>
            <pc:docMk/>
            <pc:sldMk cId="236126241" sldId="257"/>
            <ac:cxnSpMk id="141" creationId="{57C9CA1E-12FE-AD76-826A-C2669E8F9C91}"/>
          </ac:cxnSpMkLst>
        </pc:cxnChg>
      </pc:sldChg>
    </pc:docChg>
  </pc:docChgLst>
  <pc:docChgLst>
    <pc:chgData name="JUAN MANUEL LOZANO GIL" userId="618ed11e-cb2c-4b03-8ac9-a8cf52f924c9" providerId="ADAL" clId="{2C754AFD-733E-4F0A-A56C-4CCF838AEA10}"/>
    <pc:docChg chg="custSel delSld modSld">
      <pc:chgData name="JUAN MANUEL LOZANO GIL" userId="618ed11e-cb2c-4b03-8ac9-a8cf52f924c9" providerId="ADAL" clId="{2C754AFD-733E-4F0A-A56C-4CCF838AEA10}" dt="2023-07-19T13:21:41.669" v="374" actId="478"/>
      <pc:docMkLst>
        <pc:docMk/>
      </pc:docMkLst>
      <pc:sldChg chg="del">
        <pc:chgData name="JUAN MANUEL LOZANO GIL" userId="618ed11e-cb2c-4b03-8ac9-a8cf52f924c9" providerId="ADAL" clId="{2C754AFD-733E-4F0A-A56C-4CCF838AEA10}" dt="2023-07-19T12:16:27.661" v="2" actId="47"/>
        <pc:sldMkLst>
          <pc:docMk/>
          <pc:sldMk cId="1035658693" sldId="256"/>
        </pc:sldMkLst>
      </pc:sldChg>
      <pc:sldChg chg="addSp delSp modSp mod">
        <pc:chgData name="JUAN MANUEL LOZANO GIL" userId="618ed11e-cb2c-4b03-8ac9-a8cf52f924c9" providerId="ADAL" clId="{2C754AFD-733E-4F0A-A56C-4CCF838AEA10}" dt="2023-07-19T13:21:41.669" v="374" actId="478"/>
        <pc:sldMkLst>
          <pc:docMk/>
          <pc:sldMk cId="236126241" sldId="257"/>
        </pc:sldMkLst>
        <pc:spChg chg="mod">
          <ac:chgData name="JUAN MANUEL LOZANO GIL" userId="618ed11e-cb2c-4b03-8ac9-a8cf52f924c9" providerId="ADAL" clId="{2C754AFD-733E-4F0A-A56C-4CCF838AEA10}" dt="2023-07-19T12:24:12.958" v="207" actId="1036"/>
          <ac:spMkLst>
            <pc:docMk/>
            <pc:sldMk cId="236126241" sldId="257"/>
            <ac:spMk id="16" creationId="{004BF03E-1D72-3441-66DB-949991E03FD6}"/>
          </ac:spMkLst>
        </pc:spChg>
        <pc:spChg chg="mod">
          <ac:chgData name="JUAN MANUEL LOZANO GIL" userId="618ed11e-cb2c-4b03-8ac9-a8cf52f924c9" providerId="ADAL" clId="{2C754AFD-733E-4F0A-A56C-4CCF838AEA10}" dt="2023-07-19T12:18:03.182" v="35" actId="1076"/>
          <ac:spMkLst>
            <pc:docMk/>
            <pc:sldMk cId="236126241" sldId="257"/>
            <ac:spMk id="18" creationId="{61D6E092-9B1B-66F5-E077-9BEB59D9A1C9}"/>
          </ac:spMkLst>
        </pc:spChg>
        <pc:spChg chg="mod">
          <ac:chgData name="JUAN MANUEL LOZANO GIL" userId="618ed11e-cb2c-4b03-8ac9-a8cf52f924c9" providerId="ADAL" clId="{2C754AFD-733E-4F0A-A56C-4CCF838AEA10}" dt="2023-07-19T12:18:07.814" v="37" actId="1076"/>
          <ac:spMkLst>
            <pc:docMk/>
            <pc:sldMk cId="236126241" sldId="257"/>
            <ac:spMk id="23" creationId="{BB07BF14-FBBC-39F2-C4C8-BD48E3FD1C37}"/>
          </ac:spMkLst>
        </pc:spChg>
        <pc:spChg chg="mod">
          <ac:chgData name="JUAN MANUEL LOZANO GIL" userId="618ed11e-cb2c-4b03-8ac9-a8cf52f924c9" providerId="ADAL" clId="{2C754AFD-733E-4F0A-A56C-4CCF838AEA10}" dt="2023-07-19T12:18:13.310" v="38" actId="1076"/>
          <ac:spMkLst>
            <pc:docMk/>
            <pc:sldMk cId="236126241" sldId="257"/>
            <ac:spMk id="25" creationId="{1C53B108-3DE7-4A98-D5C7-5CB2540F6AF5}"/>
          </ac:spMkLst>
        </pc:spChg>
        <pc:spChg chg="del mod">
          <ac:chgData name="JUAN MANUEL LOZANO GIL" userId="618ed11e-cb2c-4b03-8ac9-a8cf52f924c9" providerId="ADAL" clId="{2C754AFD-733E-4F0A-A56C-4CCF838AEA10}" dt="2023-07-19T12:17:52.967" v="33" actId="478"/>
          <ac:spMkLst>
            <pc:docMk/>
            <pc:sldMk cId="236126241" sldId="257"/>
            <ac:spMk id="28" creationId="{8ECA5BE9-CEF0-86BD-F518-332E43228C31}"/>
          </ac:spMkLst>
        </pc:spChg>
        <pc:spChg chg="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29" creationId="{2135E244-1F3B-7BF0-3F61-E9745CC66162}"/>
          </ac:spMkLst>
        </pc:spChg>
        <pc:spChg chg="mod or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30" creationId="{E74161A8-0EA0-0E29-6DB3-12E4B8BA11B5}"/>
          </ac:spMkLst>
        </pc:spChg>
        <pc:spChg chg="del">
          <ac:chgData name="JUAN MANUEL LOZANO GIL" userId="618ed11e-cb2c-4b03-8ac9-a8cf52f924c9" providerId="ADAL" clId="{2C754AFD-733E-4F0A-A56C-4CCF838AEA10}" dt="2023-07-19T12:16:24.606" v="1" actId="478"/>
          <ac:spMkLst>
            <pc:docMk/>
            <pc:sldMk cId="236126241" sldId="257"/>
            <ac:spMk id="31" creationId="{84D3EA54-4A00-DE9C-7E19-0C088717B835}"/>
          </ac:spMkLst>
        </pc:spChg>
        <pc:spChg chg="del">
          <ac:chgData name="JUAN MANUEL LOZANO GIL" userId="618ed11e-cb2c-4b03-8ac9-a8cf52f924c9" providerId="ADAL" clId="{2C754AFD-733E-4F0A-A56C-4CCF838AEA10}" dt="2023-07-19T12:16:24.606" v="1" actId="478"/>
          <ac:spMkLst>
            <pc:docMk/>
            <pc:sldMk cId="236126241" sldId="257"/>
            <ac:spMk id="32" creationId="{935DF1CE-9C86-BAEA-FCBC-116924EE940B}"/>
          </ac:spMkLst>
        </pc:spChg>
        <pc:spChg chg="del mod">
          <ac:chgData name="JUAN MANUEL LOZANO GIL" userId="618ed11e-cb2c-4b03-8ac9-a8cf52f924c9" providerId="ADAL" clId="{2C754AFD-733E-4F0A-A56C-4CCF838AEA10}" dt="2023-07-19T12:17:50.407" v="32" actId="478"/>
          <ac:spMkLst>
            <pc:docMk/>
            <pc:sldMk cId="236126241" sldId="257"/>
            <ac:spMk id="34" creationId="{247046FE-DF86-CF08-1D4A-3D48398249ED}"/>
          </ac:spMkLst>
        </pc:spChg>
        <pc:spChg chg="del mod">
          <ac:chgData name="JUAN MANUEL LOZANO GIL" userId="618ed11e-cb2c-4b03-8ac9-a8cf52f924c9" providerId="ADAL" clId="{2C754AFD-733E-4F0A-A56C-4CCF838AEA10}" dt="2023-07-19T12:17:45.390" v="29" actId="478"/>
          <ac:spMkLst>
            <pc:docMk/>
            <pc:sldMk cId="236126241" sldId="257"/>
            <ac:spMk id="35" creationId="{AB8EAAEB-222C-D1F1-5888-8D9933713971}"/>
          </ac:spMkLst>
        </pc:spChg>
        <pc:spChg chg="del mod">
          <ac:chgData name="JUAN MANUEL LOZANO GIL" userId="618ed11e-cb2c-4b03-8ac9-a8cf52f924c9" providerId="ADAL" clId="{2C754AFD-733E-4F0A-A56C-4CCF838AEA10}" dt="2023-07-19T12:17:43.790" v="28" actId="478"/>
          <ac:spMkLst>
            <pc:docMk/>
            <pc:sldMk cId="236126241" sldId="257"/>
            <ac:spMk id="36" creationId="{24BED31E-8D2C-BF85-2EE5-9B0A3B1A4C8E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44" creationId="{E7F871D1-DD2C-1CDC-89C0-9E126769601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5" creationId="{98AE03D9-FDF9-A915-BF73-D611CF569C4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6" creationId="{58B01AA3-91AC-F63F-F050-653F649E7EA1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7" creationId="{4B22347D-0C44-ECC2-4A87-5A947201C2B5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8" creationId="{4646C71E-F31D-136E-1727-1EE0F1C6FDD0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49" creationId="{93A62BB7-F385-F9A6-002D-A1A15CD2E919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0" creationId="{142547B8-3FED-FBBB-A1C1-B24ECB545C35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1" creationId="{2AE99E3E-5EA5-28B4-990D-C6FE82C6D11A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2" creationId="{71EE4F11-A1E8-6C82-6CA4-0D2C993E6536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3" creationId="{51F8C930-0D7A-9854-EF3B-6B87716D26BA}"/>
          </ac:spMkLst>
        </pc:spChg>
        <pc:spChg chg="add mod">
          <ac:chgData name="JUAN MANUEL LOZANO GIL" userId="618ed11e-cb2c-4b03-8ac9-a8cf52f924c9" providerId="ADAL" clId="{2C754AFD-733E-4F0A-A56C-4CCF838AEA10}" dt="2023-07-19T12:19:17.113" v="48" actId="164"/>
          <ac:spMkLst>
            <pc:docMk/>
            <pc:sldMk cId="236126241" sldId="257"/>
            <ac:spMk id="54" creationId="{54E3A0E3-A904-3548-6384-7A687C9BCA42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58" creationId="{43A1FED4-B30E-3905-0EF1-17DA44FC7FB8}"/>
          </ac:spMkLst>
        </pc:spChg>
        <pc:spChg chg="add mod">
          <ac:chgData name="JUAN MANUEL LOZANO GIL" userId="618ed11e-cb2c-4b03-8ac9-a8cf52f924c9" providerId="ADAL" clId="{2C754AFD-733E-4F0A-A56C-4CCF838AEA10}" dt="2023-07-19T12:27:02.029" v="236" actId="1076"/>
          <ac:spMkLst>
            <pc:docMk/>
            <pc:sldMk cId="236126241" sldId="257"/>
            <ac:spMk id="59" creationId="{A473DF37-5308-B1AF-C511-0D15B7EE8B94}"/>
          </ac:spMkLst>
        </pc:spChg>
        <pc:spChg chg="add del mod">
          <ac:chgData name="JUAN MANUEL LOZANO GIL" userId="618ed11e-cb2c-4b03-8ac9-a8cf52f924c9" providerId="ADAL" clId="{2C754AFD-733E-4F0A-A56C-4CCF838AEA10}" dt="2023-07-19T12:22:48.502" v="87" actId="478"/>
          <ac:spMkLst>
            <pc:docMk/>
            <pc:sldMk cId="236126241" sldId="257"/>
            <ac:spMk id="60" creationId="{8305FE67-9F02-2733-51BE-A57F93CAB82E}"/>
          </ac:spMkLst>
        </pc:spChg>
        <pc:spChg chg="mod">
          <ac:chgData name="JUAN MANUEL LOZANO GIL" userId="618ed11e-cb2c-4b03-8ac9-a8cf52f924c9" providerId="ADAL" clId="{2C754AFD-733E-4F0A-A56C-4CCF838AEA10}" dt="2023-07-19T12:23:31.599" v="102" actId="1035"/>
          <ac:spMkLst>
            <pc:docMk/>
            <pc:sldMk cId="236126241" sldId="257"/>
            <ac:spMk id="65" creationId="{264484C2-2B45-D946-F22F-2C34231B1762}"/>
          </ac:spMkLst>
        </pc:spChg>
        <pc:spChg chg="mod">
          <ac:chgData name="JUAN MANUEL LOZANO GIL" userId="618ed11e-cb2c-4b03-8ac9-a8cf52f924c9" providerId="ADAL" clId="{2C754AFD-733E-4F0A-A56C-4CCF838AEA10}" dt="2023-07-19T12:23:37.743" v="123" actId="1036"/>
          <ac:spMkLst>
            <pc:docMk/>
            <pc:sldMk cId="236126241" sldId="257"/>
            <ac:spMk id="66" creationId="{BD0FAB52-B17A-8882-61F6-79F727941CDD}"/>
          </ac:spMkLst>
        </pc:spChg>
        <pc:spChg chg="mod">
          <ac:chgData name="JUAN MANUEL LOZANO GIL" userId="618ed11e-cb2c-4b03-8ac9-a8cf52f924c9" providerId="ADAL" clId="{2C754AFD-733E-4F0A-A56C-4CCF838AEA10}" dt="2023-07-19T12:23:41.318" v="133" actId="1035"/>
          <ac:spMkLst>
            <pc:docMk/>
            <pc:sldMk cId="236126241" sldId="257"/>
            <ac:spMk id="67" creationId="{422FDD0B-58C7-4479-0D00-95C4EF43A919}"/>
          </ac:spMkLst>
        </pc:spChg>
        <pc:spChg chg="mod">
          <ac:chgData name="JUAN MANUEL LOZANO GIL" userId="618ed11e-cb2c-4b03-8ac9-a8cf52f924c9" providerId="ADAL" clId="{2C754AFD-733E-4F0A-A56C-4CCF838AEA10}" dt="2023-07-19T12:23:50.342" v="153" actId="1035"/>
          <ac:spMkLst>
            <pc:docMk/>
            <pc:sldMk cId="236126241" sldId="257"/>
            <ac:spMk id="68" creationId="{E95384B0-D4F4-3A37-E705-0174266AE06C}"/>
          </ac:spMkLst>
        </pc:spChg>
        <pc:spChg chg="mod">
          <ac:chgData name="JUAN MANUEL LOZANO GIL" userId="618ed11e-cb2c-4b03-8ac9-a8cf52f924c9" providerId="ADAL" clId="{2C754AFD-733E-4F0A-A56C-4CCF838AEA10}" dt="2023-07-19T12:24:34.847" v="214" actId="1035"/>
          <ac:spMkLst>
            <pc:docMk/>
            <pc:sldMk cId="236126241" sldId="257"/>
            <ac:spMk id="69" creationId="{AAC3DCE8-3FCF-C02C-D2CA-3AB16CC97201}"/>
          </ac:spMkLst>
        </pc:spChg>
        <pc:spChg chg="mod">
          <ac:chgData name="JUAN MANUEL LOZANO GIL" userId="618ed11e-cb2c-4b03-8ac9-a8cf52f924c9" providerId="ADAL" clId="{2C754AFD-733E-4F0A-A56C-4CCF838AEA10}" dt="2023-07-19T12:23:59.784" v="179" actId="1036"/>
          <ac:spMkLst>
            <pc:docMk/>
            <pc:sldMk cId="236126241" sldId="257"/>
            <ac:spMk id="70" creationId="{A6BEE17A-6AC2-1FFA-2986-9F214E1B461D}"/>
          </ac:spMkLst>
        </pc:spChg>
        <pc:spChg chg="mod">
          <ac:chgData name="JUAN MANUEL LOZANO GIL" userId="618ed11e-cb2c-4b03-8ac9-a8cf52f924c9" providerId="ADAL" clId="{2C754AFD-733E-4F0A-A56C-4CCF838AEA10}" dt="2023-07-19T12:24:04.486" v="189" actId="1036"/>
          <ac:spMkLst>
            <pc:docMk/>
            <pc:sldMk cId="236126241" sldId="257"/>
            <ac:spMk id="71" creationId="{91FA0395-1622-D6EE-6203-A3EFA130F284}"/>
          </ac:spMkLst>
        </pc:spChg>
        <pc:spChg chg="add mod">
          <ac:chgData name="JUAN MANUEL LOZANO GIL" userId="618ed11e-cb2c-4b03-8ac9-a8cf52f924c9" providerId="ADAL" clId="{2C754AFD-733E-4F0A-A56C-4CCF838AEA10}" dt="2023-07-19T12:27:12.532" v="239" actId="1076"/>
          <ac:spMkLst>
            <pc:docMk/>
            <pc:sldMk cId="236126241" sldId="257"/>
            <ac:spMk id="79" creationId="{A9EBDE9A-BBBC-92B4-5028-2898417ACC40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1" creationId="{BF6AA894-E2FB-95AF-4F87-AE16A58A4970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2" creationId="{9BB808CB-8826-9D29-A760-FD8CC4C8C536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3" creationId="{19F6353B-6BC6-1E74-833C-8366F077556B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4" creationId="{6CBC606F-BBBF-C9D3-6B63-E0C9A252924F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5" creationId="{F95CB61D-B67F-C671-8EEC-C42DA5F9C48F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6" creationId="{06287408-6066-1D4F-C1CB-FE893812E6B4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7" creationId="{47D65355-B992-99AC-CCAE-8676E903C207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8" creationId="{D622BBC7-0991-ED56-FDB8-251651B1C64E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89" creationId="{926C9AE2-1916-4490-A534-860017AEC50E}"/>
          </ac:spMkLst>
        </pc:spChg>
        <pc:spChg chg="mod">
          <ac:chgData name="JUAN MANUEL LOZANO GIL" userId="618ed11e-cb2c-4b03-8ac9-a8cf52f924c9" providerId="ADAL" clId="{2C754AFD-733E-4F0A-A56C-4CCF838AEA10}" dt="2023-07-19T12:24:54.618" v="219"/>
          <ac:spMkLst>
            <pc:docMk/>
            <pc:sldMk cId="236126241" sldId="257"/>
            <ac:spMk id="90" creationId="{4B47116D-8C5C-E550-99EC-4C0B7A47AC6B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7" creationId="{35494226-F88F-EB79-62C1-F164BC2B2A0A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8" creationId="{BE3B2D01-FE87-52B5-FF92-4ACACF3D3C3E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99" creationId="{C856674C-8346-A320-1D81-4515FC19ACCD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0" creationId="{D17C37FB-3A21-317D-90A7-838E6E866E55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1" creationId="{59F67548-5A65-5136-6217-E9D2F25207BE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2" creationId="{887B108D-B102-96CD-32F0-192E66B9CE55}"/>
          </ac:spMkLst>
        </pc:spChg>
        <pc:spChg chg="mod">
          <ac:chgData name="JUAN MANUEL LOZANO GIL" userId="618ed11e-cb2c-4b03-8ac9-a8cf52f924c9" providerId="ADAL" clId="{2C754AFD-733E-4F0A-A56C-4CCF838AEA10}" dt="2023-07-19T12:27:19.577" v="241"/>
          <ac:spMkLst>
            <pc:docMk/>
            <pc:sldMk cId="236126241" sldId="257"/>
            <ac:spMk id="103" creationId="{F2CA8EB3-90D8-E3CA-DF1D-24CB13506E39}"/>
          </ac:spMkLst>
        </pc:spChg>
        <pc:spChg chg="add mod">
          <ac:chgData name="JUAN MANUEL LOZANO GIL" userId="618ed11e-cb2c-4b03-8ac9-a8cf52f924c9" providerId="ADAL" clId="{2C754AFD-733E-4F0A-A56C-4CCF838AEA10}" dt="2023-07-19T12:27:38.141" v="244" actId="1076"/>
          <ac:spMkLst>
            <pc:docMk/>
            <pc:sldMk cId="236126241" sldId="257"/>
            <ac:spMk id="111" creationId="{639D055B-F362-C4D7-03B5-C623AAFF4CA5}"/>
          </ac:spMkLst>
        </pc:spChg>
        <pc:spChg chg="add mod">
          <ac:chgData name="JUAN MANUEL LOZANO GIL" userId="618ed11e-cb2c-4b03-8ac9-a8cf52f924c9" providerId="ADAL" clId="{2C754AFD-733E-4F0A-A56C-4CCF838AEA10}" dt="2023-07-19T12:27:49.349" v="253" actId="20577"/>
          <ac:spMkLst>
            <pc:docMk/>
            <pc:sldMk cId="236126241" sldId="257"/>
            <ac:spMk id="112" creationId="{17DE7CD4-CEF5-1A3C-4405-DC9E90863427}"/>
          </ac:spMkLst>
        </pc:spChg>
        <pc:spChg chg="add mod">
          <ac:chgData name="JUAN MANUEL LOZANO GIL" userId="618ed11e-cb2c-4b03-8ac9-a8cf52f924c9" providerId="ADAL" clId="{2C754AFD-733E-4F0A-A56C-4CCF838AEA10}" dt="2023-07-19T12:27:58.589" v="274" actId="20577"/>
          <ac:spMkLst>
            <pc:docMk/>
            <pc:sldMk cId="236126241" sldId="257"/>
            <ac:spMk id="113" creationId="{B9F64BC0-143F-F0DC-D338-6209797FBA4D}"/>
          </ac:spMkLst>
        </pc:spChg>
        <pc:spChg chg="add mod">
          <ac:chgData name="JUAN MANUEL LOZANO GIL" userId="618ed11e-cb2c-4b03-8ac9-a8cf52f924c9" providerId="ADAL" clId="{2C754AFD-733E-4F0A-A56C-4CCF838AEA10}" dt="2023-07-19T12:31:02.128" v="295" actId="1038"/>
          <ac:spMkLst>
            <pc:docMk/>
            <pc:sldMk cId="236126241" sldId="257"/>
            <ac:spMk id="115" creationId="{E793D70F-9D4F-DC80-0EF0-00F9547C648D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3" creationId="{4EFDD4F5-A310-5A9D-D0D8-3EB1A1F51018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4" creationId="{C0CAD623-1A46-A801-44D6-6CF913CB1CE1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5" creationId="{63692FFD-C2A6-492D-F288-F2585429AF8E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6" creationId="{EC4458D4-FBD8-6190-6B26-3D00D1D89286}"/>
          </ac:spMkLst>
        </pc:spChg>
        <pc:spChg chg="mod">
          <ac:chgData name="JUAN MANUEL LOZANO GIL" userId="618ed11e-cb2c-4b03-8ac9-a8cf52f924c9" providerId="ADAL" clId="{2C754AFD-733E-4F0A-A56C-4CCF838AEA10}" dt="2023-07-19T12:32:06.259" v="309"/>
          <ac:spMkLst>
            <pc:docMk/>
            <pc:sldMk cId="236126241" sldId="257"/>
            <ac:spMk id="127" creationId="{961280BA-7786-8C92-D276-A40CC0886686}"/>
          </ac:spMkLst>
        </pc:spChg>
        <pc:spChg chg="del mod">
          <ac:chgData name="JUAN MANUEL LOZANO GIL" userId="618ed11e-cb2c-4b03-8ac9-a8cf52f924c9" providerId="ADAL" clId="{2C754AFD-733E-4F0A-A56C-4CCF838AEA10}" dt="2023-07-19T13:21:40.165" v="373" actId="478"/>
          <ac:spMkLst>
            <pc:docMk/>
            <pc:sldMk cId="236126241" sldId="257"/>
            <ac:spMk id="128" creationId="{964CA77A-DC57-B783-3517-A2254AFE9958}"/>
          </ac:spMkLst>
        </pc:spChg>
        <pc:spChg chg="del mod">
          <ac:chgData name="JUAN MANUEL LOZANO GIL" userId="618ed11e-cb2c-4b03-8ac9-a8cf52f924c9" providerId="ADAL" clId="{2C754AFD-733E-4F0A-A56C-4CCF838AEA10}" dt="2023-07-19T13:21:41.669" v="374" actId="478"/>
          <ac:spMkLst>
            <pc:docMk/>
            <pc:sldMk cId="236126241" sldId="257"/>
            <ac:spMk id="129" creationId="{DED6A395-8D45-F228-8E64-9FABFAAD2333}"/>
          </ac:spMkLst>
        </pc:spChg>
        <pc:spChg chg="add mod">
          <ac:chgData name="JUAN MANUEL LOZANO GIL" userId="618ed11e-cb2c-4b03-8ac9-a8cf52f924c9" providerId="ADAL" clId="{2C754AFD-733E-4F0A-A56C-4CCF838AEA10}" dt="2023-07-19T12:32:42.436" v="368" actId="20577"/>
          <ac:spMkLst>
            <pc:docMk/>
            <pc:sldMk cId="236126241" sldId="257"/>
            <ac:spMk id="137" creationId="{132FFF07-291A-65D4-EBB7-545D316F222E}"/>
          </ac:spMkLst>
        </pc:spChg>
        <pc:grpChg chg="add 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6" creationId="{80952FC4-A08B-B3D7-D07B-CE6C844A14A9}"/>
          </ac:grpSpMkLst>
        </pc:grpChg>
        <pc:grpChg chg="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8" creationId="{6ECEC6D2-B89B-EC32-D2E5-16233731C6B3}"/>
          </ac:grpSpMkLst>
        </pc:grpChg>
        <pc:grpChg chg="mod">
          <ac:chgData name="JUAN MANUEL LOZANO GIL" userId="618ed11e-cb2c-4b03-8ac9-a8cf52f924c9" providerId="ADAL" clId="{2C754AFD-733E-4F0A-A56C-4CCF838AEA10}" dt="2023-07-19T12:16:44.860" v="10"/>
          <ac:grpSpMkLst>
            <pc:docMk/>
            <pc:sldMk cId="236126241" sldId="257"/>
            <ac:grpSpMk id="17" creationId="{6455B4FE-16A5-904F-4250-A5C54999BF2A}"/>
          </ac:grpSpMkLst>
        </pc:grpChg>
        <pc:grpChg chg="add mod">
          <ac:chgData name="JUAN MANUEL LOZANO GIL" userId="618ed11e-cb2c-4b03-8ac9-a8cf52f924c9" providerId="ADAL" clId="{2C754AFD-733E-4F0A-A56C-4CCF838AEA10}" dt="2023-07-19T12:27:02.029" v="236" actId="1076"/>
          <ac:grpSpMkLst>
            <pc:docMk/>
            <pc:sldMk cId="236126241" sldId="257"/>
            <ac:grpSpMk id="55" creationId="{310D0092-15C0-5BAC-78B3-2FF9B3258CF6}"/>
          </ac:grpSpMkLst>
        </pc:grpChg>
        <pc:grpChg chg="add mod">
          <ac:chgData name="JUAN MANUEL LOZANO GIL" userId="618ed11e-cb2c-4b03-8ac9-a8cf52f924c9" providerId="ADAL" clId="{2C754AFD-733E-4F0A-A56C-4CCF838AEA10}" dt="2023-07-19T12:27:12.532" v="239" actId="1076"/>
          <ac:grpSpMkLst>
            <pc:docMk/>
            <pc:sldMk cId="236126241" sldId="257"/>
            <ac:grpSpMk id="63" creationId="{B51C5646-7A41-6ABE-0BD8-D3D0365DF8F3}"/>
          </ac:grpSpMkLst>
        </pc:grpChg>
        <pc:grpChg chg="mod">
          <ac:chgData name="JUAN MANUEL LOZANO GIL" userId="618ed11e-cb2c-4b03-8ac9-a8cf52f924c9" providerId="ADAL" clId="{2C754AFD-733E-4F0A-A56C-4CCF838AEA10}" dt="2023-07-19T12:23:07.099" v="95"/>
          <ac:grpSpMkLst>
            <pc:docMk/>
            <pc:sldMk cId="236126241" sldId="257"/>
            <ac:grpSpMk id="64" creationId="{1075AE8B-341E-AFAD-D913-A6A8B22A5847}"/>
          </ac:grpSpMkLst>
        </pc:grpChg>
        <pc:grpChg chg="add del mod">
          <ac:chgData name="JUAN MANUEL LOZANO GIL" userId="618ed11e-cb2c-4b03-8ac9-a8cf52f924c9" providerId="ADAL" clId="{2C754AFD-733E-4F0A-A56C-4CCF838AEA10}" dt="2023-07-19T12:27:06.420" v="238" actId="478"/>
          <ac:grpSpMkLst>
            <pc:docMk/>
            <pc:sldMk cId="236126241" sldId="257"/>
            <ac:grpSpMk id="80" creationId="{530C55CE-1A1B-B605-F056-8A0F7CB03741}"/>
          </ac:grpSpMkLst>
        </pc:grpChg>
        <pc:grpChg chg="add mod">
          <ac:chgData name="JUAN MANUEL LOZANO GIL" userId="618ed11e-cb2c-4b03-8ac9-a8cf52f924c9" providerId="ADAL" clId="{2C754AFD-733E-4F0A-A56C-4CCF838AEA10}" dt="2023-07-19T12:27:26.230" v="242" actId="1076"/>
          <ac:grpSpMkLst>
            <pc:docMk/>
            <pc:sldMk cId="236126241" sldId="257"/>
            <ac:grpSpMk id="95" creationId="{9A88576D-03BD-A42B-E63C-E85294663A8C}"/>
          </ac:grpSpMkLst>
        </pc:grpChg>
        <pc:grpChg chg="mod">
          <ac:chgData name="JUAN MANUEL LOZANO GIL" userId="618ed11e-cb2c-4b03-8ac9-a8cf52f924c9" providerId="ADAL" clId="{2C754AFD-733E-4F0A-A56C-4CCF838AEA10}" dt="2023-07-19T12:27:19.577" v="241"/>
          <ac:grpSpMkLst>
            <pc:docMk/>
            <pc:sldMk cId="236126241" sldId="257"/>
            <ac:grpSpMk id="96" creationId="{4B3DF87F-D8DD-2DA7-B47B-6D34F3CDBB29}"/>
          </ac:grpSpMkLst>
        </pc:grpChg>
        <pc:grpChg chg="add del mod">
          <ac:chgData name="JUAN MANUEL LOZANO GIL" userId="618ed11e-cb2c-4b03-8ac9-a8cf52f924c9" providerId="ADAL" clId="{2C754AFD-733E-4F0A-A56C-4CCF838AEA10}" dt="2023-07-19T12:32:27.701" v="349" actId="478"/>
          <ac:grpSpMkLst>
            <pc:docMk/>
            <pc:sldMk cId="236126241" sldId="257"/>
            <ac:grpSpMk id="120" creationId="{3F9F9ABB-BDB0-4862-294F-0EECDA83AD17}"/>
          </ac:grpSpMkLst>
        </pc:grpChg>
        <pc:grpChg chg="add mod">
          <ac:chgData name="JUAN MANUEL LOZANO GIL" userId="618ed11e-cb2c-4b03-8ac9-a8cf52f924c9" providerId="ADAL" clId="{2C754AFD-733E-4F0A-A56C-4CCF838AEA10}" dt="2023-07-19T12:32:25.537" v="348" actId="1038"/>
          <ac:grpSpMkLst>
            <pc:docMk/>
            <pc:sldMk cId="236126241" sldId="257"/>
            <ac:grpSpMk id="121" creationId="{F7DD65EB-E362-A17D-3E97-08606792C1C6}"/>
          </ac:grpSpMkLst>
        </pc:grpChg>
        <pc:grpChg chg="mod">
          <ac:chgData name="JUAN MANUEL LOZANO GIL" userId="618ed11e-cb2c-4b03-8ac9-a8cf52f924c9" providerId="ADAL" clId="{2C754AFD-733E-4F0A-A56C-4CCF838AEA10}" dt="2023-07-19T12:32:06.259" v="309"/>
          <ac:grpSpMkLst>
            <pc:docMk/>
            <pc:sldMk cId="236126241" sldId="257"/>
            <ac:grpSpMk id="122" creationId="{1C32FCD2-50E1-2A71-B970-B936B563E03A}"/>
          </ac:grpSpMkLst>
        </pc:grpChg>
        <pc:picChg chg="add mod modCrop">
          <ac:chgData name="JUAN MANUEL LOZANO GIL" userId="618ed11e-cb2c-4b03-8ac9-a8cf52f924c9" providerId="ADAL" clId="{2C754AFD-733E-4F0A-A56C-4CCF838AEA10}" dt="2023-07-19T12:27:02.029" v="236" actId="1076"/>
          <ac:picMkLst>
            <pc:docMk/>
            <pc:sldMk cId="236126241" sldId="257"/>
            <ac:picMk id="3" creationId="{42A409BF-BF62-2408-5370-A1AC57EDC83F}"/>
          </ac:picMkLst>
        </pc:picChg>
        <pc:picChg chg="add del mod ord">
          <ac:chgData name="JUAN MANUEL LOZANO GIL" userId="618ed11e-cb2c-4b03-8ac9-a8cf52f924c9" providerId="ADAL" clId="{2C754AFD-733E-4F0A-A56C-4CCF838AEA10}" dt="2023-07-19T12:17:14.510" v="21" actId="478"/>
          <ac:picMkLst>
            <pc:docMk/>
            <pc:sldMk cId="236126241" sldId="257"/>
            <ac:picMk id="5" creationId="{A2560D1A-CD36-E40B-49D1-9EC6256B9DEB}"/>
          </ac:picMkLst>
        </pc:picChg>
        <pc:picChg chg="del">
          <ac:chgData name="JUAN MANUEL LOZANO GIL" userId="618ed11e-cb2c-4b03-8ac9-a8cf52f924c9" providerId="ADAL" clId="{2C754AFD-733E-4F0A-A56C-4CCF838AEA10}" dt="2023-07-19T12:16:22.607" v="0" actId="478"/>
          <ac:picMkLst>
            <pc:docMk/>
            <pc:sldMk cId="236126241" sldId="257"/>
            <ac:picMk id="7" creationId="{249F3737-2ECA-678D-A59E-494C5B48DC52}"/>
          </ac:picMkLst>
        </pc:picChg>
        <pc:picChg chg="add mod ord modCrop">
          <ac:chgData name="JUAN MANUEL LOZANO GIL" userId="618ed11e-cb2c-4b03-8ac9-a8cf52f924c9" providerId="ADAL" clId="{2C754AFD-733E-4F0A-A56C-4CCF838AEA10}" dt="2023-07-19T12:27:02.029" v="236" actId="1076"/>
          <ac:picMkLst>
            <pc:docMk/>
            <pc:sldMk cId="236126241" sldId="257"/>
            <ac:picMk id="57" creationId="{1219A44C-029A-7585-8F53-35D405D37E24}"/>
          </ac:picMkLst>
        </pc:picChg>
        <pc:picChg chg="add mod modCrop">
          <ac:chgData name="JUAN MANUEL LOZANO GIL" userId="618ed11e-cb2c-4b03-8ac9-a8cf52f924c9" providerId="ADAL" clId="{2C754AFD-733E-4F0A-A56C-4CCF838AEA10}" dt="2023-07-19T12:27:12.532" v="239" actId="1076"/>
          <ac:picMkLst>
            <pc:docMk/>
            <pc:sldMk cId="236126241" sldId="257"/>
            <ac:picMk id="62" creationId="{F2141D81-4FA9-8618-E836-00E38748E7EF}"/>
          </ac:picMkLst>
        </pc:picChg>
        <pc:picChg chg="add del mod">
          <ac:chgData name="JUAN MANUEL LOZANO GIL" userId="618ed11e-cb2c-4b03-8ac9-a8cf52f924c9" providerId="ADAL" clId="{2C754AFD-733E-4F0A-A56C-4CCF838AEA10}" dt="2023-07-19T12:26:34.901" v="231" actId="478"/>
          <ac:picMkLst>
            <pc:docMk/>
            <pc:sldMk cId="236126241" sldId="257"/>
            <ac:picMk id="92" creationId="{7B793B6A-E421-496D-D7AF-67EBC04DDE26}"/>
          </ac:picMkLst>
        </pc:picChg>
        <pc:picChg chg="add mod modCrop">
          <ac:chgData name="JUAN MANUEL LOZANO GIL" userId="618ed11e-cb2c-4b03-8ac9-a8cf52f924c9" providerId="ADAL" clId="{2C754AFD-733E-4F0A-A56C-4CCF838AEA10}" dt="2023-07-19T12:28:02.260" v="275" actId="208"/>
          <ac:picMkLst>
            <pc:docMk/>
            <pc:sldMk cId="236126241" sldId="257"/>
            <ac:picMk id="94" creationId="{430E5B00-1908-D489-1059-7458EC9A0E10}"/>
          </ac:picMkLst>
        </pc:picChg>
        <pc:picChg chg="add mod modCrop">
          <ac:chgData name="JUAN MANUEL LOZANO GIL" userId="618ed11e-cb2c-4b03-8ac9-a8cf52f924c9" providerId="ADAL" clId="{2C754AFD-733E-4F0A-A56C-4CCF838AEA10}" dt="2023-07-19T13:21:33.477" v="369" actId="732"/>
          <ac:picMkLst>
            <pc:docMk/>
            <pc:sldMk cId="236126241" sldId="257"/>
            <ac:picMk id="114" creationId="{988EA5B1-B066-B493-0A18-66216AB290AC}"/>
          </ac:picMkLst>
        </pc:picChg>
        <pc:picChg chg="add mod">
          <ac:chgData name="JUAN MANUEL LOZANO GIL" userId="618ed11e-cb2c-4b03-8ac9-a8cf52f924c9" providerId="ADAL" clId="{2C754AFD-733E-4F0A-A56C-4CCF838AEA10}" dt="2023-07-19T12:31:53.639" v="306" actId="164"/>
          <ac:picMkLst>
            <pc:docMk/>
            <pc:sldMk cId="236126241" sldId="257"/>
            <ac:picMk id="117" creationId="{DE3B0CA6-A20F-1714-B3C2-1AD12A10E4C3}"/>
          </ac:picMkLst>
        </pc:picChg>
        <pc:picChg chg="add mod">
          <ac:chgData name="JUAN MANUEL LOZANO GIL" userId="618ed11e-cb2c-4b03-8ac9-a8cf52f924c9" providerId="ADAL" clId="{2C754AFD-733E-4F0A-A56C-4CCF838AEA10}" dt="2023-07-19T12:31:53.639" v="306" actId="164"/>
          <ac:picMkLst>
            <pc:docMk/>
            <pc:sldMk cId="236126241" sldId="257"/>
            <ac:picMk id="119" creationId="{E8AC02B2-6B6B-9B10-0F9F-B0ACBE6189F5}"/>
          </ac:picMkLst>
        </pc:picChg>
        <pc:cxnChg chg="mod">
          <ac:chgData name="JUAN MANUEL LOZANO GIL" userId="618ed11e-cb2c-4b03-8ac9-a8cf52f924c9" providerId="ADAL" clId="{2C754AFD-733E-4F0A-A56C-4CCF838AEA10}" dt="2023-07-19T12:24:12.958" v="207" actId="1036"/>
          <ac:cxnSpMkLst>
            <pc:docMk/>
            <pc:sldMk cId="236126241" sldId="257"/>
            <ac:cxnSpMk id="27" creationId="{73122490-A3EF-1CCF-57A2-73126CB81FBC}"/>
          </ac:cxnSpMkLst>
        </pc:cxnChg>
        <pc:cxnChg chg="del">
          <ac:chgData name="JUAN MANUEL LOZANO GIL" userId="618ed11e-cb2c-4b03-8ac9-a8cf52f924c9" providerId="ADAL" clId="{2C754AFD-733E-4F0A-A56C-4CCF838AEA10}" dt="2023-07-19T12:16:24.606" v="1" actId="478"/>
          <ac:cxnSpMkLst>
            <pc:docMk/>
            <pc:sldMk cId="236126241" sldId="257"/>
            <ac:cxnSpMk id="33" creationId="{6AB4F24E-2418-3177-99FE-E328E98D14F3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37" creationId="{DF18E5A8-3C20-F91C-9330-3CA751B7F91C}"/>
          </ac:cxnSpMkLst>
        </pc:cxnChg>
        <pc:cxnChg chg="mod">
          <ac:chgData name="JUAN MANUEL LOZANO GIL" userId="618ed11e-cb2c-4b03-8ac9-a8cf52f924c9" providerId="ADAL" clId="{2C754AFD-733E-4F0A-A56C-4CCF838AEA10}" dt="2023-07-19T12:16:55.935" v="17" actId="1035"/>
          <ac:cxnSpMkLst>
            <pc:docMk/>
            <pc:sldMk cId="236126241" sldId="257"/>
            <ac:cxnSpMk id="38" creationId="{F12B26A2-6E5B-FA81-00BD-C1F290B8598A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39" creationId="{259E7E14-5B40-8674-882B-2222280D664F}"/>
          </ac:cxnSpMkLst>
        </pc:cxnChg>
        <pc:cxnChg chg="mod">
          <ac:chgData name="JUAN MANUEL LOZANO GIL" userId="618ed11e-cb2c-4b03-8ac9-a8cf52f924c9" providerId="ADAL" clId="{2C754AFD-733E-4F0A-A56C-4CCF838AEA10}" dt="2023-07-19T12:16:44.860" v="10"/>
          <ac:cxnSpMkLst>
            <pc:docMk/>
            <pc:sldMk cId="236126241" sldId="257"/>
            <ac:cxnSpMk id="40" creationId="{05F33000-8D74-1AD7-6444-941A53DB300E}"/>
          </ac:cxnSpMkLst>
        </pc:cxnChg>
        <pc:cxnChg chg="del mod">
          <ac:chgData name="JUAN MANUEL LOZANO GIL" userId="618ed11e-cb2c-4b03-8ac9-a8cf52f924c9" providerId="ADAL" clId="{2C754AFD-733E-4F0A-A56C-4CCF838AEA10}" dt="2023-07-19T12:17:49.207" v="31" actId="478"/>
          <ac:cxnSpMkLst>
            <pc:docMk/>
            <pc:sldMk cId="236126241" sldId="257"/>
            <ac:cxnSpMk id="41" creationId="{43D52F60-1132-575F-2595-92DBFDD0D155}"/>
          </ac:cxnSpMkLst>
        </pc:cxnChg>
        <pc:cxnChg chg="del mod">
          <ac:chgData name="JUAN MANUEL LOZANO GIL" userId="618ed11e-cb2c-4b03-8ac9-a8cf52f924c9" providerId="ADAL" clId="{2C754AFD-733E-4F0A-A56C-4CCF838AEA10}" dt="2023-07-19T12:17:47.063" v="30" actId="478"/>
          <ac:cxnSpMkLst>
            <pc:docMk/>
            <pc:sldMk cId="236126241" sldId="257"/>
            <ac:cxnSpMk id="42" creationId="{A974288E-379A-34C6-F048-6DDF7B40580E}"/>
          </ac:cxnSpMkLst>
        </pc:cxnChg>
        <pc:cxnChg chg="del mod">
          <ac:chgData name="JUAN MANUEL LOZANO GIL" userId="618ed11e-cb2c-4b03-8ac9-a8cf52f924c9" providerId="ADAL" clId="{2C754AFD-733E-4F0A-A56C-4CCF838AEA10}" dt="2023-07-19T12:17:42.519" v="27" actId="478"/>
          <ac:cxnSpMkLst>
            <pc:docMk/>
            <pc:sldMk cId="236126241" sldId="257"/>
            <ac:cxnSpMk id="43" creationId="{8495E7F3-A12B-655E-728E-366E991C17AB}"/>
          </ac:cxnSpMkLst>
        </pc:cxnChg>
        <pc:cxnChg chg="mod">
          <ac:chgData name="JUAN MANUEL LOZANO GIL" userId="618ed11e-cb2c-4b03-8ac9-a8cf52f924c9" providerId="ADAL" clId="{2C754AFD-733E-4F0A-A56C-4CCF838AEA10}" dt="2023-07-19T12:23:31.599" v="102" actId="1035"/>
          <ac:cxnSpMkLst>
            <pc:docMk/>
            <pc:sldMk cId="236126241" sldId="257"/>
            <ac:cxnSpMk id="72" creationId="{9062BE9B-9E10-D835-FA50-B05DA551B59D}"/>
          </ac:cxnSpMkLst>
        </pc:cxnChg>
        <pc:cxnChg chg="mod">
          <ac:chgData name="JUAN MANUEL LOZANO GIL" userId="618ed11e-cb2c-4b03-8ac9-a8cf52f924c9" providerId="ADAL" clId="{2C754AFD-733E-4F0A-A56C-4CCF838AEA10}" dt="2023-07-19T12:23:37.743" v="123" actId="1036"/>
          <ac:cxnSpMkLst>
            <pc:docMk/>
            <pc:sldMk cId="236126241" sldId="257"/>
            <ac:cxnSpMk id="73" creationId="{180CFFF9-77ED-F079-90C7-33E207643A5B}"/>
          </ac:cxnSpMkLst>
        </pc:cxnChg>
        <pc:cxnChg chg="mod">
          <ac:chgData name="JUAN MANUEL LOZANO GIL" userId="618ed11e-cb2c-4b03-8ac9-a8cf52f924c9" providerId="ADAL" clId="{2C754AFD-733E-4F0A-A56C-4CCF838AEA10}" dt="2023-07-19T12:23:41.318" v="133" actId="1035"/>
          <ac:cxnSpMkLst>
            <pc:docMk/>
            <pc:sldMk cId="236126241" sldId="257"/>
            <ac:cxnSpMk id="74" creationId="{63941729-08C1-D7C8-88D7-E976BF5EA169}"/>
          </ac:cxnSpMkLst>
        </pc:cxnChg>
        <pc:cxnChg chg="mod">
          <ac:chgData name="JUAN MANUEL LOZANO GIL" userId="618ed11e-cb2c-4b03-8ac9-a8cf52f924c9" providerId="ADAL" clId="{2C754AFD-733E-4F0A-A56C-4CCF838AEA10}" dt="2023-07-19T12:23:50.342" v="153" actId="1035"/>
          <ac:cxnSpMkLst>
            <pc:docMk/>
            <pc:sldMk cId="236126241" sldId="257"/>
            <ac:cxnSpMk id="75" creationId="{B6A8A7B0-86FE-E44E-B623-15AD9865DC63}"/>
          </ac:cxnSpMkLst>
        </pc:cxnChg>
        <pc:cxnChg chg="mod">
          <ac:chgData name="JUAN MANUEL LOZANO GIL" userId="618ed11e-cb2c-4b03-8ac9-a8cf52f924c9" providerId="ADAL" clId="{2C754AFD-733E-4F0A-A56C-4CCF838AEA10}" dt="2023-07-19T12:24:34.847" v="214" actId="1035"/>
          <ac:cxnSpMkLst>
            <pc:docMk/>
            <pc:sldMk cId="236126241" sldId="257"/>
            <ac:cxnSpMk id="76" creationId="{3492D2D1-34BB-14BF-E35A-1D4C26308134}"/>
          </ac:cxnSpMkLst>
        </pc:cxnChg>
        <pc:cxnChg chg="mod">
          <ac:chgData name="JUAN MANUEL LOZANO GIL" userId="618ed11e-cb2c-4b03-8ac9-a8cf52f924c9" providerId="ADAL" clId="{2C754AFD-733E-4F0A-A56C-4CCF838AEA10}" dt="2023-07-19T12:23:59.784" v="179" actId="1036"/>
          <ac:cxnSpMkLst>
            <pc:docMk/>
            <pc:sldMk cId="236126241" sldId="257"/>
            <ac:cxnSpMk id="77" creationId="{6B68C81B-783E-A086-A5F7-C0B112D558B9}"/>
          </ac:cxnSpMkLst>
        </pc:cxnChg>
        <pc:cxnChg chg="mod">
          <ac:chgData name="JUAN MANUEL LOZANO GIL" userId="618ed11e-cb2c-4b03-8ac9-a8cf52f924c9" providerId="ADAL" clId="{2C754AFD-733E-4F0A-A56C-4CCF838AEA10}" dt="2023-07-19T12:24:04.486" v="189" actId="1036"/>
          <ac:cxnSpMkLst>
            <pc:docMk/>
            <pc:sldMk cId="236126241" sldId="257"/>
            <ac:cxnSpMk id="78" creationId="{0D5D2EB7-6300-07EC-5D1C-A6EC85433634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4" creationId="{40D41830-67CB-3C72-52FD-467D42572DED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5" creationId="{2A94A489-27E5-AD34-A159-B35D12E68C16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6" creationId="{8F41F395-110D-4CAB-A530-99D069A33846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7" creationId="{996EB4DB-030B-B199-ED06-B064270EA2C2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8" creationId="{53C76150-5999-E5A9-80AD-9A6205CFEE7D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09" creationId="{1F475A3C-C14D-01BE-0BCE-524EE951391E}"/>
          </ac:cxnSpMkLst>
        </pc:cxnChg>
        <pc:cxnChg chg="mod">
          <ac:chgData name="JUAN MANUEL LOZANO GIL" userId="618ed11e-cb2c-4b03-8ac9-a8cf52f924c9" providerId="ADAL" clId="{2C754AFD-733E-4F0A-A56C-4CCF838AEA10}" dt="2023-07-19T12:27:19.577" v="241"/>
          <ac:cxnSpMkLst>
            <pc:docMk/>
            <pc:sldMk cId="236126241" sldId="257"/>
            <ac:cxnSpMk id="110" creationId="{CD607DE3-1F26-4AB7-1A61-51F5BB60ABC2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0" creationId="{9BAE5784-6473-4203-3431-4EA9A566E9F6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1" creationId="{53B626AC-27CD-74C6-EB4F-7DFCF9E6E038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2" creationId="{5426DB23-4980-18AC-742B-8E9B370498DB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3" creationId="{8020D6D1-2C45-7A34-1EA2-5401F73F3D0C}"/>
          </ac:cxnSpMkLst>
        </pc:cxnChg>
        <pc:cxnChg chg="mod">
          <ac:chgData name="JUAN MANUEL LOZANO GIL" userId="618ed11e-cb2c-4b03-8ac9-a8cf52f924c9" providerId="ADAL" clId="{2C754AFD-733E-4F0A-A56C-4CCF838AEA10}" dt="2023-07-19T12:32:06.259" v="309"/>
          <ac:cxnSpMkLst>
            <pc:docMk/>
            <pc:sldMk cId="236126241" sldId="257"/>
            <ac:cxnSpMk id="134" creationId="{75396E36-C0DE-B193-1BF8-BE5F3487E6EC}"/>
          </ac:cxnSpMkLst>
        </pc:cxnChg>
        <pc:cxnChg chg="del mod">
          <ac:chgData name="JUAN MANUEL LOZANO GIL" userId="618ed11e-cb2c-4b03-8ac9-a8cf52f924c9" providerId="ADAL" clId="{2C754AFD-733E-4F0A-A56C-4CCF838AEA10}" dt="2023-07-19T13:21:39.013" v="371" actId="478"/>
          <ac:cxnSpMkLst>
            <pc:docMk/>
            <pc:sldMk cId="236126241" sldId="257"/>
            <ac:cxnSpMk id="135" creationId="{D9C103FF-69FC-FF6E-6796-E296C73BEEE1}"/>
          </ac:cxnSpMkLst>
        </pc:cxnChg>
        <pc:cxnChg chg="del mod">
          <ac:chgData name="JUAN MANUEL LOZANO GIL" userId="618ed11e-cb2c-4b03-8ac9-a8cf52f924c9" providerId="ADAL" clId="{2C754AFD-733E-4F0A-A56C-4CCF838AEA10}" dt="2023-07-19T13:21:37.613" v="370" actId="478"/>
          <ac:cxnSpMkLst>
            <pc:docMk/>
            <pc:sldMk cId="236126241" sldId="257"/>
            <ac:cxnSpMk id="136" creationId="{5E26008F-486E-6FD3-B33E-9FBDF9FFFF4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6822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2165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4898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2237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2615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9928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4861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3827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6832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8339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741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55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6ECEC6D2-B89B-EC32-D2E5-16233731C6B3}"/>
              </a:ext>
            </a:extLst>
          </p:cNvPr>
          <p:cNvGrpSpPr/>
          <p:nvPr/>
        </p:nvGrpSpPr>
        <p:grpSpPr>
          <a:xfrm>
            <a:off x="549953" y="2550884"/>
            <a:ext cx="882876" cy="1654379"/>
            <a:chOff x="4523309" y="3719311"/>
            <a:chExt cx="747936" cy="744093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FBB40FF9-F291-150D-61CF-821F5A252FE8}"/>
                </a:ext>
              </a:extLst>
            </p:cNvPr>
            <p:cNvGrpSpPr/>
            <p:nvPr/>
          </p:nvGrpSpPr>
          <p:grpSpPr>
            <a:xfrm>
              <a:off x="4999646" y="3809004"/>
              <a:ext cx="271599" cy="536337"/>
              <a:chOff x="4999646" y="3809004"/>
              <a:chExt cx="271599" cy="536337"/>
            </a:xfrm>
          </p:grpSpPr>
          <p:cxnSp>
            <p:nvCxnSpPr>
              <p:cNvPr id="22" name="Conector recto 21">
                <a:extLst>
                  <a:ext uri="{FF2B5EF4-FFF2-40B4-BE49-F238E27FC236}">
                    <a16:creationId xmlns:a16="http://schemas.microsoft.com/office/drawing/2014/main" id="{19A39EC1-E3D3-F676-75C7-32340632D8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4" name="Conector recto 23">
                <a:extLst>
                  <a:ext uri="{FF2B5EF4-FFF2-40B4-BE49-F238E27FC236}">
                    <a16:creationId xmlns:a16="http://schemas.microsoft.com/office/drawing/2014/main" id="{665D59D2-5E30-C130-8B3D-560E6D0A07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ector recto 25">
                <a:extLst>
                  <a:ext uri="{FF2B5EF4-FFF2-40B4-BE49-F238E27FC236}">
                    <a16:creationId xmlns:a16="http://schemas.microsoft.com/office/drawing/2014/main" id="{2DBAE913-8726-4919-0D4F-164BAC8D7D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ector recto 26">
                <a:extLst>
                  <a:ext uri="{FF2B5EF4-FFF2-40B4-BE49-F238E27FC236}">
                    <a16:creationId xmlns:a16="http://schemas.microsoft.com/office/drawing/2014/main" id="{73122490-A3EF-1CCF-57A2-73126CB81F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45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691369C1-1220-FF9C-CECC-883C8C62DF9B}"/>
                </a:ext>
              </a:extLst>
            </p:cNvPr>
            <p:cNvSpPr txBox="1"/>
            <p:nvPr/>
          </p:nvSpPr>
          <p:spPr>
            <a:xfrm>
              <a:off x="4526408" y="371931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B4074FA-5243-54A2-EC82-CC6810F1078D}"/>
                </a:ext>
              </a:extLst>
            </p:cNvPr>
            <p:cNvSpPr txBox="1"/>
            <p:nvPr/>
          </p:nvSpPr>
          <p:spPr>
            <a:xfrm>
              <a:off x="4525817" y="3853888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DAD07FD7-BCCB-78CA-A0D3-57B576949E63}"/>
                </a:ext>
              </a:extLst>
            </p:cNvPr>
            <p:cNvSpPr txBox="1"/>
            <p:nvPr/>
          </p:nvSpPr>
          <p:spPr>
            <a:xfrm>
              <a:off x="4526408" y="401387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004BF03E-1D72-3441-66DB-949991E03FD6}"/>
                </a:ext>
              </a:extLst>
            </p:cNvPr>
            <p:cNvSpPr txBox="1"/>
            <p:nvPr/>
          </p:nvSpPr>
          <p:spPr>
            <a:xfrm>
              <a:off x="4523309" y="423874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135E244-1F3B-7BF0-3F61-E9745CC66162}"/>
              </a:ext>
            </a:extLst>
          </p:cNvPr>
          <p:cNvSpPr txBox="1"/>
          <p:nvPr/>
        </p:nvSpPr>
        <p:spPr>
          <a:xfrm>
            <a:off x="6253386" y="1493884"/>
            <a:ext cx="52610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NLRP1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id="{80952FC4-A08B-B3D7-D07B-CE6C844A14A9}"/>
              </a:ext>
            </a:extLst>
          </p:cNvPr>
          <p:cNvGrpSpPr/>
          <p:nvPr/>
        </p:nvGrpSpPr>
        <p:grpSpPr>
          <a:xfrm>
            <a:off x="380284" y="1259918"/>
            <a:ext cx="937585" cy="941730"/>
            <a:chOff x="4476963" y="3125466"/>
            <a:chExt cx="794284" cy="729076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6455B4FE-16A5-904F-4250-A5C54999BF2A}"/>
                </a:ext>
              </a:extLst>
            </p:cNvPr>
            <p:cNvGrpSpPr/>
            <p:nvPr/>
          </p:nvGrpSpPr>
          <p:grpSpPr>
            <a:xfrm>
              <a:off x="4999651" y="3310666"/>
              <a:ext cx="271596" cy="338847"/>
              <a:chOff x="4999651" y="3310666"/>
              <a:chExt cx="271596" cy="338847"/>
            </a:xfrm>
          </p:grpSpPr>
          <p:cxnSp>
            <p:nvCxnSpPr>
              <p:cNvPr id="37" name="Conector recto 36">
                <a:extLst>
                  <a:ext uri="{FF2B5EF4-FFF2-40B4-BE49-F238E27FC236}">
                    <a16:creationId xmlns:a16="http://schemas.microsoft.com/office/drawing/2014/main" id="{DF18E5A8-3C20-F91C-9330-3CA751B7F9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F12B26A2-6E5B-FA81-00BD-C1F290B859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48364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>
                <a:extLst>
                  <a:ext uri="{FF2B5EF4-FFF2-40B4-BE49-F238E27FC236}">
                    <a16:creationId xmlns:a16="http://schemas.microsoft.com/office/drawing/2014/main" id="{259E7E14-5B40-8674-882B-2222280D66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61D6E092-9B1B-66F5-E077-9BEB59D9A1C9}"/>
                </a:ext>
              </a:extLst>
            </p:cNvPr>
            <p:cNvSpPr txBox="1"/>
            <p:nvPr/>
          </p:nvSpPr>
          <p:spPr>
            <a:xfrm>
              <a:off x="4476963" y="3125466"/>
              <a:ext cx="532608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BB07BF14-FBBC-39F2-C4C8-BD48E3FD1C37}"/>
                </a:ext>
              </a:extLst>
            </p:cNvPr>
            <p:cNvSpPr txBox="1"/>
            <p:nvPr/>
          </p:nvSpPr>
          <p:spPr>
            <a:xfrm>
              <a:off x="4483997" y="3297983"/>
              <a:ext cx="532607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1C53B108-3DE7-4A98-D5C7-5CB2540F6AF5}"/>
                </a:ext>
              </a:extLst>
            </p:cNvPr>
            <p:cNvSpPr txBox="1"/>
            <p:nvPr/>
          </p:nvSpPr>
          <p:spPr>
            <a:xfrm>
              <a:off x="4546463" y="3464504"/>
              <a:ext cx="470140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</p:grpSp>
      <p:sp>
        <p:nvSpPr>
          <p:cNvPr id="59" name="CuadroTexto 58">
            <a:extLst>
              <a:ext uri="{FF2B5EF4-FFF2-40B4-BE49-F238E27FC236}">
                <a16:creationId xmlns:a16="http://schemas.microsoft.com/office/drawing/2014/main" id="{A473DF37-5308-B1AF-C511-0D15B7EE8B94}"/>
              </a:ext>
            </a:extLst>
          </p:cNvPr>
          <p:cNvSpPr txBox="1"/>
          <p:nvPr/>
        </p:nvSpPr>
        <p:spPr>
          <a:xfrm>
            <a:off x="6102372" y="3455543"/>
            <a:ext cx="54534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GATA1</a:t>
            </a:r>
          </a:p>
        </p:txBody>
      </p:sp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B9A29602-3B2B-DD44-D8BE-6CEB0AD042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488" t="25070" r="15702" b="40119"/>
          <a:stretch/>
        </p:blipFill>
        <p:spPr>
          <a:xfrm>
            <a:off x="1199632" y="918201"/>
            <a:ext cx="4902740" cy="14820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Rectángulo 29">
            <a:extLst>
              <a:ext uri="{FF2B5EF4-FFF2-40B4-BE49-F238E27FC236}">
                <a16:creationId xmlns:a16="http://schemas.microsoft.com/office/drawing/2014/main" id="{E74161A8-0EA0-0E29-6DB3-12E4B8BA11B5}"/>
              </a:ext>
            </a:extLst>
          </p:cNvPr>
          <p:cNvSpPr/>
          <p:nvPr/>
        </p:nvSpPr>
        <p:spPr>
          <a:xfrm>
            <a:off x="2753958" y="1394734"/>
            <a:ext cx="3285303" cy="3689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pic>
        <p:nvPicPr>
          <p:cNvPr id="28" name="Imagen 27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8AD8BB02-6E84-B20D-CFA5-45CB8888B76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77" r="18593" b="34490"/>
          <a:stretch/>
        </p:blipFill>
        <p:spPr>
          <a:xfrm>
            <a:off x="1446337" y="2438523"/>
            <a:ext cx="4652377" cy="25304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Imagen 3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1792F7B4-0C44-48D8-B046-B044722301F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92" t="26190" r="14213" b="31623"/>
          <a:stretch/>
        </p:blipFill>
        <p:spPr>
          <a:xfrm>
            <a:off x="1446336" y="5070164"/>
            <a:ext cx="4652377" cy="19840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CuadroTexto 32">
            <a:extLst>
              <a:ext uri="{FF2B5EF4-FFF2-40B4-BE49-F238E27FC236}">
                <a16:creationId xmlns:a16="http://schemas.microsoft.com/office/drawing/2014/main" id="{E84F3B63-AEA0-463A-26D3-86C8A9B02E3E}"/>
              </a:ext>
            </a:extLst>
          </p:cNvPr>
          <p:cNvSpPr txBox="1"/>
          <p:nvPr/>
        </p:nvSpPr>
        <p:spPr>
          <a:xfrm>
            <a:off x="6083136" y="5938103"/>
            <a:ext cx="58381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 err="1"/>
              <a:t>ZAKalfa</a:t>
            </a:r>
            <a:endParaRPr lang="es-ES" sz="1013" dirty="0"/>
          </a:p>
        </p:txBody>
      </p:sp>
      <p:grpSp>
        <p:nvGrpSpPr>
          <p:cNvPr id="34" name="Grupo 33">
            <a:extLst>
              <a:ext uri="{FF2B5EF4-FFF2-40B4-BE49-F238E27FC236}">
                <a16:creationId xmlns:a16="http://schemas.microsoft.com/office/drawing/2014/main" id="{B979160C-197B-6B2D-A99B-1BCF502DDA93}"/>
              </a:ext>
            </a:extLst>
          </p:cNvPr>
          <p:cNvGrpSpPr/>
          <p:nvPr/>
        </p:nvGrpSpPr>
        <p:grpSpPr>
          <a:xfrm>
            <a:off x="508751" y="5688682"/>
            <a:ext cx="937585" cy="881400"/>
            <a:chOff x="4476963" y="3125466"/>
            <a:chExt cx="794284" cy="729076"/>
          </a:xfrm>
        </p:grpSpPr>
        <p:grpSp>
          <p:nvGrpSpPr>
            <p:cNvPr id="35" name="Grupo 34">
              <a:extLst>
                <a:ext uri="{FF2B5EF4-FFF2-40B4-BE49-F238E27FC236}">
                  <a16:creationId xmlns:a16="http://schemas.microsoft.com/office/drawing/2014/main" id="{95F63A75-BD18-74D5-E9DD-FE2E63AAE768}"/>
                </a:ext>
              </a:extLst>
            </p:cNvPr>
            <p:cNvGrpSpPr/>
            <p:nvPr/>
          </p:nvGrpSpPr>
          <p:grpSpPr>
            <a:xfrm>
              <a:off x="4999651" y="3310666"/>
              <a:ext cx="271596" cy="338847"/>
              <a:chOff x="4999651" y="3310666"/>
              <a:chExt cx="271596" cy="338847"/>
            </a:xfrm>
          </p:grpSpPr>
          <p:cxnSp>
            <p:nvCxnSpPr>
              <p:cNvPr id="43" name="Conector recto 42">
                <a:extLst>
                  <a:ext uri="{FF2B5EF4-FFF2-40B4-BE49-F238E27FC236}">
                    <a16:creationId xmlns:a16="http://schemas.microsoft.com/office/drawing/2014/main" id="{3EC6B81A-EC95-2D71-9A47-EA6936FE7C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ector recto 55">
                <a:extLst>
                  <a:ext uri="{FF2B5EF4-FFF2-40B4-BE49-F238E27FC236}">
                    <a16:creationId xmlns:a16="http://schemas.microsoft.com/office/drawing/2014/main" id="{BFA666DC-BD86-0425-C9B8-FB10CCB1D0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48364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ector recto 59">
                <a:extLst>
                  <a:ext uri="{FF2B5EF4-FFF2-40B4-BE49-F238E27FC236}">
                    <a16:creationId xmlns:a16="http://schemas.microsoft.com/office/drawing/2014/main" id="{0D63E881-38F8-2ABE-0F80-DBBD87A280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DAABA48B-B2B3-BBEC-3ACC-764D180C2708}"/>
                </a:ext>
              </a:extLst>
            </p:cNvPr>
            <p:cNvSpPr txBox="1"/>
            <p:nvPr/>
          </p:nvSpPr>
          <p:spPr>
            <a:xfrm>
              <a:off x="4476963" y="3125466"/>
              <a:ext cx="532608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82kDa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5EC7EF27-1BCF-FC91-4135-696DD1E00414}"/>
                </a:ext>
              </a:extLst>
            </p:cNvPr>
            <p:cNvSpPr txBox="1"/>
            <p:nvPr/>
          </p:nvSpPr>
          <p:spPr>
            <a:xfrm>
              <a:off x="4483997" y="3297983"/>
              <a:ext cx="532607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116kDa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D3F7CDF9-2D08-35FE-534A-018A37B597EB}"/>
                </a:ext>
              </a:extLst>
            </p:cNvPr>
            <p:cNvSpPr txBox="1"/>
            <p:nvPr/>
          </p:nvSpPr>
          <p:spPr>
            <a:xfrm>
              <a:off x="4546463" y="3464504"/>
              <a:ext cx="470140" cy="390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82kDa</a:t>
              </a:r>
            </a:p>
          </p:txBody>
        </p:sp>
      </p:grpSp>
      <p:pic>
        <p:nvPicPr>
          <p:cNvPr id="80" name="Imagen 79" descr="Gráfico&#10;&#10;Descripción generada automáticamente">
            <a:extLst>
              <a:ext uri="{FF2B5EF4-FFF2-40B4-BE49-F238E27FC236}">
                <a16:creationId xmlns:a16="http://schemas.microsoft.com/office/drawing/2014/main" id="{ADB22CC1-C9F5-9A71-B0AA-4CFDCDABAB1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7" r="18357" b="39439"/>
          <a:stretch/>
        </p:blipFill>
        <p:spPr>
          <a:xfrm>
            <a:off x="1432824" y="7114098"/>
            <a:ext cx="4665889" cy="245599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1" name="Grupo 80">
            <a:extLst>
              <a:ext uri="{FF2B5EF4-FFF2-40B4-BE49-F238E27FC236}">
                <a16:creationId xmlns:a16="http://schemas.microsoft.com/office/drawing/2014/main" id="{640AE604-F08C-9D15-EE5E-6E29F7C127F2}"/>
              </a:ext>
            </a:extLst>
          </p:cNvPr>
          <p:cNvGrpSpPr/>
          <p:nvPr/>
        </p:nvGrpSpPr>
        <p:grpSpPr>
          <a:xfrm>
            <a:off x="563459" y="7514903"/>
            <a:ext cx="882876" cy="1654379"/>
            <a:chOff x="4523309" y="3719311"/>
            <a:chExt cx="747936" cy="744093"/>
          </a:xfrm>
        </p:grpSpPr>
        <p:grpSp>
          <p:nvGrpSpPr>
            <p:cNvPr id="82" name="Grupo 81">
              <a:extLst>
                <a:ext uri="{FF2B5EF4-FFF2-40B4-BE49-F238E27FC236}">
                  <a16:creationId xmlns:a16="http://schemas.microsoft.com/office/drawing/2014/main" id="{319FE988-8403-4E2E-D344-EEF3DDD9691A}"/>
                </a:ext>
              </a:extLst>
            </p:cNvPr>
            <p:cNvGrpSpPr/>
            <p:nvPr/>
          </p:nvGrpSpPr>
          <p:grpSpPr>
            <a:xfrm>
              <a:off x="4999646" y="3809004"/>
              <a:ext cx="271599" cy="536337"/>
              <a:chOff x="4999646" y="3809004"/>
              <a:chExt cx="271599" cy="536337"/>
            </a:xfrm>
          </p:grpSpPr>
          <p:cxnSp>
            <p:nvCxnSpPr>
              <p:cNvPr id="87" name="Conector recto 86">
                <a:extLst>
                  <a:ext uri="{FF2B5EF4-FFF2-40B4-BE49-F238E27FC236}">
                    <a16:creationId xmlns:a16="http://schemas.microsoft.com/office/drawing/2014/main" id="{02E4A975-4F3C-0C6C-0608-4BFA90E852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88" name="Conector recto 87">
                <a:extLst>
                  <a:ext uri="{FF2B5EF4-FFF2-40B4-BE49-F238E27FC236}">
                    <a16:creationId xmlns:a16="http://schemas.microsoft.com/office/drawing/2014/main" id="{49A77370-E557-A471-DE3C-2933F2F225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ector recto 88">
                <a:extLst>
                  <a:ext uri="{FF2B5EF4-FFF2-40B4-BE49-F238E27FC236}">
                    <a16:creationId xmlns:a16="http://schemas.microsoft.com/office/drawing/2014/main" id="{B2268782-932F-64E4-5F48-97256AF585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ector recto 89">
                <a:extLst>
                  <a:ext uri="{FF2B5EF4-FFF2-40B4-BE49-F238E27FC236}">
                    <a16:creationId xmlns:a16="http://schemas.microsoft.com/office/drawing/2014/main" id="{B09D455F-AC68-FA93-0F33-AFB61EF138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45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3F804669-B2D2-40E0-3234-126D2340E4EA}"/>
                </a:ext>
              </a:extLst>
            </p:cNvPr>
            <p:cNvSpPr txBox="1"/>
            <p:nvPr/>
          </p:nvSpPr>
          <p:spPr>
            <a:xfrm>
              <a:off x="4526408" y="371931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B13C7076-D656-FDEA-9EB7-258D7CAE4647}"/>
                </a:ext>
              </a:extLst>
            </p:cNvPr>
            <p:cNvSpPr txBox="1"/>
            <p:nvPr/>
          </p:nvSpPr>
          <p:spPr>
            <a:xfrm>
              <a:off x="4525817" y="3853888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85" name="CuadroTexto 84">
              <a:extLst>
                <a:ext uri="{FF2B5EF4-FFF2-40B4-BE49-F238E27FC236}">
                  <a16:creationId xmlns:a16="http://schemas.microsoft.com/office/drawing/2014/main" id="{448BA4DF-C99D-4F67-0220-62F111FE6C43}"/>
                </a:ext>
              </a:extLst>
            </p:cNvPr>
            <p:cNvSpPr txBox="1"/>
            <p:nvPr/>
          </p:nvSpPr>
          <p:spPr>
            <a:xfrm>
              <a:off x="4526408" y="401387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86" name="CuadroTexto 85">
              <a:extLst>
                <a:ext uri="{FF2B5EF4-FFF2-40B4-BE49-F238E27FC236}">
                  <a16:creationId xmlns:a16="http://schemas.microsoft.com/office/drawing/2014/main" id="{BBF0D648-66C5-B5A9-ACC0-C85374772E5A}"/>
                </a:ext>
              </a:extLst>
            </p:cNvPr>
            <p:cNvSpPr txBox="1"/>
            <p:nvPr/>
          </p:nvSpPr>
          <p:spPr>
            <a:xfrm>
              <a:off x="4523309" y="423874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sp>
        <p:nvSpPr>
          <p:cNvPr id="91" name="CuadroTexto 90">
            <a:extLst>
              <a:ext uri="{FF2B5EF4-FFF2-40B4-BE49-F238E27FC236}">
                <a16:creationId xmlns:a16="http://schemas.microsoft.com/office/drawing/2014/main" id="{24414E85-2A5D-D8FA-1C6C-BFC9A7224972}"/>
              </a:ext>
            </a:extLst>
          </p:cNvPr>
          <p:cNvSpPr txBox="1"/>
          <p:nvPr/>
        </p:nvSpPr>
        <p:spPr>
          <a:xfrm>
            <a:off x="6121211" y="7939759"/>
            <a:ext cx="46198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/>
              <a:t>ACTB</a:t>
            </a:r>
          </a:p>
        </p:txBody>
      </p:sp>
      <p:sp>
        <p:nvSpPr>
          <p:cNvPr id="92" name="Rectángulo 91">
            <a:extLst>
              <a:ext uri="{FF2B5EF4-FFF2-40B4-BE49-F238E27FC236}">
                <a16:creationId xmlns:a16="http://schemas.microsoft.com/office/drawing/2014/main" id="{AFA1D7EA-9ED5-0626-47B4-54BE33663C48}"/>
              </a:ext>
            </a:extLst>
          </p:cNvPr>
          <p:cNvSpPr/>
          <p:nvPr/>
        </p:nvSpPr>
        <p:spPr>
          <a:xfrm>
            <a:off x="2753957" y="2976093"/>
            <a:ext cx="3285303" cy="3689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93" name="Rectángulo 92">
            <a:extLst>
              <a:ext uri="{FF2B5EF4-FFF2-40B4-BE49-F238E27FC236}">
                <a16:creationId xmlns:a16="http://schemas.microsoft.com/office/drawing/2014/main" id="{88C948C3-E068-7CC6-0930-663F68B23AA9}"/>
              </a:ext>
            </a:extLst>
          </p:cNvPr>
          <p:cNvSpPr/>
          <p:nvPr/>
        </p:nvSpPr>
        <p:spPr>
          <a:xfrm>
            <a:off x="2643390" y="6056553"/>
            <a:ext cx="3285303" cy="3689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sp>
        <p:nvSpPr>
          <p:cNvPr id="114" name="Rectángulo 113">
            <a:extLst>
              <a:ext uri="{FF2B5EF4-FFF2-40B4-BE49-F238E27FC236}">
                <a16:creationId xmlns:a16="http://schemas.microsoft.com/office/drawing/2014/main" id="{5E095BFE-D42C-9B6C-5AE5-3D9EF0E78916}"/>
              </a:ext>
            </a:extLst>
          </p:cNvPr>
          <p:cNvSpPr/>
          <p:nvPr/>
        </p:nvSpPr>
        <p:spPr>
          <a:xfrm>
            <a:off x="2797833" y="7939759"/>
            <a:ext cx="3285303" cy="3689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pic>
        <p:nvPicPr>
          <p:cNvPr id="116" name="Imagen 115" descr="Imagen que contiene Diagrama&#10;&#10;Descripción generada automáticamente">
            <a:extLst>
              <a:ext uri="{FF2B5EF4-FFF2-40B4-BE49-F238E27FC236}">
                <a16:creationId xmlns:a16="http://schemas.microsoft.com/office/drawing/2014/main" id="{A3C6B447-1D1E-03E9-726A-2E73DD6DD74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911" t="27200" r="23062" b="23395"/>
          <a:stretch/>
        </p:blipFill>
        <p:spPr>
          <a:xfrm>
            <a:off x="1417246" y="9690470"/>
            <a:ext cx="4665890" cy="23844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CuadroTexto 116">
            <a:extLst>
              <a:ext uri="{FF2B5EF4-FFF2-40B4-BE49-F238E27FC236}">
                <a16:creationId xmlns:a16="http://schemas.microsoft.com/office/drawing/2014/main" id="{19C9CD12-D77B-70BA-40F5-B629030DB72D}"/>
              </a:ext>
            </a:extLst>
          </p:cNvPr>
          <p:cNvSpPr txBox="1"/>
          <p:nvPr/>
        </p:nvSpPr>
        <p:spPr>
          <a:xfrm>
            <a:off x="6166512" y="10629726"/>
            <a:ext cx="700833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13" dirty="0" err="1"/>
              <a:t>Fosfo</a:t>
            </a:r>
            <a:r>
              <a:rPr lang="es-ES" sz="1013" dirty="0"/>
              <a:t> P38</a:t>
            </a:r>
          </a:p>
        </p:txBody>
      </p:sp>
      <p:sp>
        <p:nvSpPr>
          <p:cNvPr id="118" name="Rectángulo 117">
            <a:extLst>
              <a:ext uri="{FF2B5EF4-FFF2-40B4-BE49-F238E27FC236}">
                <a16:creationId xmlns:a16="http://schemas.microsoft.com/office/drawing/2014/main" id="{EF6C184F-7B1C-A70B-29EA-596902D3C766}"/>
              </a:ext>
            </a:extLst>
          </p:cNvPr>
          <p:cNvSpPr/>
          <p:nvPr/>
        </p:nvSpPr>
        <p:spPr>
          <a:xfrm>
            <a:off x="2753957" y="10445243"/>
            <a:ext cx="3285303" cy="3689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13"/>
          </a:p>
        </p:txBody>
      </p:sp>
      <p:grpSp>
        <p:nvGrpSpPr>
          <p:cNvPr id="119" name="Grupo 118">
            <a:extLst>
              <a:ext uri="{FF2B5EF4-FFF2-40B4-BE49-F238E27FC236}">
                <a16:creationId xmlns:a16="http://schemas.microsoft.com/office/drawing/2014/main" id="{F3614D40-211B-DE66-01C2-02D248374FEA}"/>
              </a:ext>
            </a:extLst>
          </p:cNvPr>
          <p:cNvGrpSpPr/>
          <p:nvPr/>
        </p:nvGrpSpPr>
        <p:grpSpPr>
          <a:xfrm>
            <a:off x="529220" y="9868820"/>
            <a:ext cx="882876" cy="1654379"/>
            <a:chOff x="4523309" y="3719311"/>
            <a:chExt cx="747936" cy="744093"/>
          </a:xfrm>
        </p:grpSpPr>
        <p:grpSp>
          <p:nvGrpSpPr>
            <p:cNvPr id="120" name="Grupo 119">
              <a:extLst>
                <a:ext uri="{FF2B5EF4-FFF2-40B4-BE49-F238E27FC236}">
                  <a16:creationId xmlns:a16="http://schemas.microsoft.com/office/drawing/2014/main" id="{29CFB9FB-ADDB-DA58-2BD4-5784A2C24CC8}"/>
                </a:ext>
              </a:extLst>
            </p:cNvPr>
            <p:cNvGrpSpPr/>
            <p:nvPr/>
          </p:nvGrpSpPr>
          <p:grpSpPr>
            <a:xfrm>
              <a:off x="4999646" y="3809004"/>
              <a:ext cx="271599" cy="536337"/>
              <a:chOff x="4999646" y="3809004"/>
              <a:chExt cx="271599" cy="536337"/>
            </a:xfrm>
          </p:grpSpPr>
          <p:cxnSp>
            <p:nvCxnSpPr>
              <p:cNvPr id="138" name="Conector recto 137">
                <a:extLst>
                  <a:ext uri="{FF2B5EF4-FFF2-40B4-BE49-F238E27FC236}">
                    <a16:creationId xmlns:a16="http://schemas.microsoft.com/office/drawing/2014/main" id="{D35EE359-AAAB-F17A-CB5F-9F84F3F51F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9" name="Conector recto 138">
                <a:extLst>
                  <a:ext uri="{FF2B5EF4-FFF2-40B4-BE49-F238E27FC236}">
                    <a16:creationId xmlns:a16="http://schemas.microsoft.com/office/drawing/2014/main" id="{D1A598F9-D6B1-B325-773C-2E5F0B9B78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Conector recto 139">
                <a:extLst>
                  <a:ext uri="{FF2B5EF4-FFF2-40B4-BE49-F238E27FC236}">
                    <a16:creationId xmlns:a16="http://schemas.microsoft.com/office/drawing/2014/main" id="{23E0326B-925B-0C6A-1810-99B1E3431A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Conector recto 140">
                <a:extLst>
                  <a:ext uri="{FF2B5EF4-FFF2-40B4-BE49-F238E27FC236}">
                    <a16:creationId xmlns:a16="http://schemas.microsoft.com/office/drawing/2014/main" id="{57C9CA1E-12FE-AD76-826A-C2669E8F9C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34534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8" name="CuadroTexto 127">
              <a:extLst>
                <a:ext uri="{FF2B5EF4-FFF2-40B4-BE49-F238E27FC236}">
                  <a16:creationId xmlns:a16="http://schemas.microsoft.com/office/drawing/2014/main" id="{74BA32B5-B0A9-0AEC-37CD-FC05BAB098E4}"/>
                </a:ext>
              </a:extLst>
            </p:cNvPr>
            <p:cNvSpPr txBox="1"/>
            <p:nvPr/>
          </p:nvSpPr>
          <p:spPr>
            <a:xfrm>
              <a:off x="4526408" y="371931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64kDa</a:t>
              </a:r>
            </a:p>
          </p:txBody>
        </p:sp>
        <p:sp>
          <p:nvSpPr>
            <p:cNvPr id="129" name="CuadroTexto 128">
              <a:extLst>
                <a:ext uri="{FF2B5EF4-FFF2-40B4-BE49-F238E27FC236}">
                  <a16:creationId xmlns:a16="http://schemas.microsoft.com/office/drawing/2014/main" id="{08CEBB25-A2E1-AA7D-31FC-F85DE589D177}"/>
                </a:ext>
              </a:extLst>
            </p:cNvPr>
            <p:cNvSpPr txBox="1"/>
            <p:nvPr/>
          </p:nvSpPr>
          <p:spPr>
            <a:xfrm>
              <a:off x="4525817" y="3853888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49kDa</a:t>
              </a:r>
            </a:p>
          </p:txBody>
        </p:sp>
        <p:sp>
          <p:nvSpPr>
            <p:cNvPr id="135" name="CuadroTexto 134">
              <a:extLst>
                <a:ext uri="{FF2B5EF4-FFF2-40B4-BE49-F238E27FC236}">
                  <a16:creationId xmlns:a16="http://schemas.microsoft.com/office/drawing/2014/main" id="{FD223CEE-86C8-A1D9-CEBB-425AB0DBC5F4}"/>
                </a:ext>
              </a:extLst>
            </p:cNvPr>
            <p:cNvSpPr txBox="1"/>
            <p:nvPr/>
          </p:nvSpPr>
          <p:spPr>
            <a:xfrm>
              <a:off x="4526408" y="4013871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37kDa</a:t>
              </a:r>
            </a:p>
          </p:txBody>
        </p:sp>
        <p:sp>
          <p:nvSpPr>
            <p:cNvPr id="136" name="CuadroTexto 135">
              <a:extLst>
                <a:ext uri="{FF2B5EF4-FFF2-40B4-BE49-F238E27FC236}">
                  <a16:creationId xmlns:a16="http://schemas.microsoft.com/office/drawing/2014/main" id="{79F4EA5C-A008-5DD9-B7FC-4484DC876F38}"/>
                </a:ext>
              </a:extLst>
            </p:cNvPr>
            <p:cNvSpPr txBox="1"/>
            <p:nvPr/>
          </p:nvSpPr>
          <p:spPr>
            <a:xfrm>
              <a:off x="4523309" y="4238744"/>
              <a:ext cx="470139" cy="224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1125" dirty="0"/>
                <a:t>26kDa</a:t>
              </a:r>
            </a:p>
          </p:txBody>
        </p:sp>
      </p:grpSp>
      <p:grpSp>
        <p:nvGrpSpPr>
          <p:cNvPr id="164" name="Grupo 163">
            <a:extLst>
              <a:ext uri="{FF2B5EF4-FFF2-40B4-BE49-F238E27FC236}">
                <a16:creationId xmlns:a16="http://schemas.microsoft.com/office/drawing/2014/main" id="{FEB60033-D526-8364-38B3-CFFDBC867A43}"/>
              </a:ext>
            </a:extLst>
          </p:cNvPr>
          <p:cNvGrpSpPr/>
          <p:nvPr/>
        </p:nvGrpSpPr>
        <p:grpSpPr>
          <a:xfrm>
            <a:off x="1664677" y="69559"/>
            <a:ext cx="4194149" cy="878699"/>
            <a:chOff x="-486770" y="10037655"/>
            <a:chExt cx="6148390" cy="1889331"/>
          </a:xfrm>
        </p:grpSpPr>
        <p:sp>
          <p:nvSpPr>
            <p:cNvPr id="142" name="CuadroTexto 141">
              <a:extLst>
                <a:ext uri="{FF2B5EF4-FFF2-40B4-BE49-F238E27FC236}">
                  <a16:creationId xmlns:a16="http://schemas.microsoft.com/office/drawing/2014/main" id="{A40CF989-C138-F77D-3189-BD21913B6001}"/>
                </a:ext>
              </a:extLst>
            </p:cNvPr>
            <p:cNvSpPr txBox="1"/>
            <p:nvPr/>
          </p:nvSpPr>
          <p:spPr>
            <a:xfrm rot="20535846">
              <a:off x="4370347" y="10077274"/>
              <a:ext cx="1092778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CX-5461</a:t>
              </a:r>
            </a:p>
          </p:txBody>
        </p:sp>
        <p:sp>
          <p:nvSpPr>
            <p:cNvPr id="143" name="Rectángulo 142">
              <a:extLst>
                <a:ext uri="{FF2B5EF4-FFF2-40B4-BE49-F238E27FC236}">
                  <a16:creationId xmlns:a16="http://schemas.microsoft.com/office/drawing/2014/main" id="{0A3D6041-80D0-8D0B-75FB-DAD76E1D4805}"/>
                </a:ext>
              </a:extLst>
            </p:cNvPr>
            <p:cNvSpPr/>
            <p:nvPr/>
          </p:nvSpPr>
          <p:spPr>
            <a:xfrm>
              <a:off x="4217868" y="11128568"/>
              <a:ext cx="1396589" cy="306211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50" dirty="0" err="1"/>
                <a:t>Nilotinib</a:t>
              </a:r>
              <a:r>
                <a:rPr lang="es-ES_tradnl" sz="1050" dirty="0"/>
                <a:t> </a:t>
              </a:r>
            </a:p>
          </p:txBody>
        </p:sp>
        <p:sp>
          <p:nvSpPr>
            <p:cNvPr id="144" name="Triángulo 203">
              <a:extLst>
                <a:ext uri="{FF2B5EF4-FFF2-40B4-BE49-F238E27FC236}">
                  <a16:creationId xmlns:a16="http://schemas.microsoft.com/office/drawing/2014/main" id="{E3297731-C514-D354-E777-8E7EE4FAF985}"/>
                </a:ext>
              </a:extLst>
            </p:cNvPr>
            <p:cNvSpPr/>
            <p:nvPr/>
          </p:nvSpPr>
          <p:spPr>
            <a:xfrm>
              <a:off x="4218443" y="10351204"/>
              <a:ext cx="1396589" cy="389274"/>
            </a:xfrm>
            <a:prstGeom prst="triangle">
              <a:avLst>
                <a:gd name="adj" fmla="val 100000"/>
              </a:avLst>
            </a:prstGeom>
            <a:gradFill>
              <a:gsLst>
                <a:gs pos="50000">
                  <a:schemeClr val="accent1">
                    <a:lumMod val="60000"/>
                    <a:lumOff val="40000"/>
                  </a:schemeClr>
                </a:gs>
                <a:gs pos="0">
                  <a:schemeClr val="accent5">
                    <a:lumMod val="20000"/>
                    <a:lumOff val="80000"/>
                  </a:schemeClr>
                </a:gs>
                <a:gs pos="100000">
                  <a:schemeClr val="accent1">
                    <a:lumMod val="98000"/>
                    <a:lumOff val="2000"/>
                  </a:schemeClr>
                </a:gs>
              </a:gsLst>
              <a:lin ang="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4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5" name="CuadroTexto 144">
              <a:extLst>
                <a:ext uri="{FF2B5EF4-FFF2-40B4-BE49-F238E27FC236}">
                  <a16:creationId xmlns:a16="http://schemas.microsoft.com/office/drawing/2014/main" id="{5283C870-8DA9-5BD6-9E7D-7316A647CBDB}"/>
                </a:ext>
              </a:extLst>
            </p:cNvPr>
            <p:cNvSpPr txBox="1"/>
            <p:nvPr/>
          </p:nvSpPr>
          <p:spPr>
            <a:xfrm rot="20535846">
              <a:off x="2852139" y="10037655"/>
              <a:ext cx="1092778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CX-5461 </a:t>
              </a:r>
            </a:p>
          </p:txBody>
        </p:sp>
        <p:sp>
          <p:nvSpPr>
            <p:cNvPr id="146" name="Triángulo 209">
              <a:extLst>
                <a:ext uri="{FF2B5EF4-FFF2-40B4-BE49-F238E27FC236}">
                  <a16:creationId xmlns:a16="http://schemas.microsoft.com/office/drawing/2014/main" id="{96C288B5-24CC-5C07-9217-9888DD8C1D46}"/>
                </a:ext>
              </a:extLst>
            </p:cNvPr>
            <p:cNvSpPr/>
            <p:nvPr/>
          </p:nvSpPr>
          <p:spPr>
            <a:xfrm>
              <a:off x="2760846" y="10311586"/>
              <a:ext cx="1335977" cy="389274"/>
            </a:xfrm>
            <a:prstGeom prst="triangle">
              <a:avLst>
                <a:gd name="adj" fmla="val 100000"/>
              </a:avLst>
            </a:prstGeom>
            <a:gradFill>
              <a:gsLst>
                <a:gs pos="50000">
                  <a:schemeClr val="accent1">
                    <a:lumMod val="60000"/>
                    <a:lumOff val="40000"/>
                  </a:schemeClr>
                </a:gs>
                <a:gs pos="0">
                  <a:schemeClr val="accent5">
                    <a:lumMod val="20000"/>
                    <a:lumOff val="80000"/>
                  </a:schemeClr>
                </a:gs>
                <a:gs pos="100000">
                  <a:schemeClr val="accent1">
                    <a:lumMod val="98000"/>
                    <a:lumOff val="2000"/>
                  </a:schemeClr>
                </a:gs>
              </a:gsLst>
              <a:lin ang="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4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7" name="Rectángulo 146">
              <a:extLst>
                <a:ext uri="{FF2B5EF4-FFF2-40B4-BE49-F238E27FC236}">
                  <a16:creationId xmlns:a16="http://schemas.microsoft.com/office/drawing/2014/main" id="{F297169B-F513-3CF2-5F88-D72B22719648}"/>
                </a:ext>
              </a:extLst>
            </p:cNvPr>
            <p:cNvSpPr/>
            <p:nvPr/>
          </p:nvSpPr>
          <p:spPr>
            <a:xfrm>
              <a:off x="2052336" y="11116057"/>
              <a:ext cx="497625" cy="306211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050" dirty="0"/>
                <a:t>Nil</a:t>
              </a:r>
            </a:p>
          </p:txBody>
        </p:sp>
        <p:sp>
          <p:nvSpPr>
            <p:cNvPr id="148" name="CuadroTexto 147">
              <a:extLst>
                <a:ext uri="{FF2B5EF4-FFF2-40B4-BE49-F238E27FC236}">
                  <a16:creationId xmlns:a16="http://schemas.microsoft.com/office/drawing/2014/main" id="{5C099CCE-BA5E-23CF-F3B7-A094B26A9EF9}"/>
                </a:ext>
              </a:extLst>
            </p:cNvPr>
            <p:cNvSpPr txBox="1"/>
            <p:nvPr/>
          </p:nvSpPr>
          <p:spPr>
            <a:xfrm rot="16200000">
              <a:off x="1501171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49" name="CuadroTexto 148">
              <a:extLst>
                <a:ext uri="{FF2B5EF4-FFF2-40B4-BE49-F238E27FC236}">
                  <a16:creationId xmlns:a16="http://schemas.microsoft.com/office/drawing/2014/main" id="{B346BB3D-B891-2B5A-C301-74B6E309FACF}"/>
                </a:ext>
              </a:extLst>
            </p:cNvPr>
            <p:cNvSpPr txBox="1"/>
            <p:nvPr/>
          </p:nvSpPr>
          <p:spPr>
            <a:xfrm rot="16200000">
              <a:off x="2009403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0" name="CuadroTexto 149">
              <a:extLst>
                <a:ext uri="{FF2B5EF4-FFF2-40B4-BE49-F238E27FC236}">
                  <a16:creationId xmlns:a16="http://schemas.microsoft.com/office/drawing/2014/main" id="{FE5CA787-A2E1-9CEA-FCF1-86C2DEA5180E}"/>
                </a:ext>
              </a:extLst>
            </p:cNvPr>
            <p:cNvSpPr txBox="1"/>
            <p:nvPr/>
          </p:nvSpPr>
          <p:spPr>
            <a:xfrm rot="16200000">
              <a:off x="2560473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1" name="CuadroTexto 150">
              <a:extLst>
                <a:ext uri="{FF2B5EF4-FFF2-40B4-BE49-F238E27FC236}">
                  <a16:creationId xmlns:a16="http://schemas.microsoft.com/office/drawing/2014/main" id="{EE5C7A38-6604-47C5-2D97-90AE89CD35CF}"/>
                </a:ext>
              </a:extLst>
            </p:cNvPr>
            <p:cNvSpPr txBox="1"/>
            <p:nvPr/>
          </p:nvSpPr>
          <p:spPr>
            <a:xfrm rot="16200000">
              <a:off x="3072774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2" name="CuadroTexto 151">
              <a:extLst>
                <a:ext uri="{FF2B5EF4-FFF2-40B4-BE49-F238E27FC236}">
                  <a16:creationId xmlns:a16="http://schemas.microsoft.com/office/drawing/2014/main" id="{68DC86E3-5457-80B1-2818-9CC69D094395}"/>
                </a:ext>
              </a:extLst>
            </p:cNvPr>
            <p:cNvSpPr txBox="1"/>
            <p:nvPr/>
          </p:nvSpPr>
          <p:spPr>
            <a:xfrm rot="16200000">
              <a:off x="3581007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3" name="CuadroTexto 152">
              <a:extLst>
                <a:ext uri="{FF2B5EF4-FFF2-40B4-BE49-F238E27FC236}">
                  <a16:creationId xmlns:a16="http://schemas.microsoft.com/office/drawing/2014/main" id="{58491170-84EA-56BA-0AC1-2A1BD29A3C62}"/>
                </a:ext>
              </a:extLst>
            </p:cNvPr>
            <p:cNvSpPr txBox="1"/>
            <p:nvPr/>
          </p:nvSpPr>
          <p:spPr>
            <a:xfrm rot="16200000">
              <a:off x="4132077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4" name="CuadroTexto 153">
              <a:extLst>
                <a:ext uri="{FF2B5EF4-FFF2-40B4-BE49-F238E27FC236}">
                  <a16:creationId xmlns:a16="http://schemas.microsoft.com/office/drawing/2014/main" id="{EC6A44D4-5318-8F7B-0423-B17231012609}"/>
                </a:ext>
              </a:extLst>
            </p:cNvPr>
            <p:cNvSpPr txBox="1"/>
            <p:nvPr/>
          </p:nvSpPr>
          <p:spPr>
            <a:xfrm rot="16200000">
              <a:off x="4589629" y="11448811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5" name="CuadroTexto 154">
              <a:extLst>
                <a:ext uri="{FF2B5EF4-FFF2-40B4-BE49-F238E27FC236}">
                  <a16:creationId xmlns:a16="http://schemas.microsoft.com/office/drawing/2014/main" id="{4025E247-E80D-AB85-E100-2E062BC744C2}"/>
                </a:ext>
              </a:extLst>
            </p:cNvPr>
            <p:cNvSpPr txBox="1"/>
            <p:nvPr/>
          </p:nvSpPr>
          <p:spPr>
            <a:xfrm rot="16200000">
              <a:off x="5097862" y="11448814"/>
              <a:ext cx="572839" cy="383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56" name="CuadroTexto 155">
              <a:extLst>
                <a:ext uri="{FF2B5EF4-FFF2-40B4-BE49-F238E27FC236}">
                  <a16:creationId xmlns:a16="http://schemas.microsoft.com/office/drawing/2014/main" id="{8D48CC7F-9ABE-9322-59A8-67605DC26AA3}"/>
                </a:ext>
              </a:extLst>
            </p:cNvPr>
            <p:cNvSpPr txBox="1"/>
            <p:nvPr/>
          </p:nvSpPr>
          <p:spPr>
            <a:xfrm>
              <a:off x="1157719" y="11363067"/>
              <a:ext cx="338859" cy="562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157" name="CuadroTexto 156">
              <a:extLst>
                <a:ext uri="{FF2B5EF4-FFF2-40B4-BE49-F238E27FC236}">
                  <a16:creationId xmlns:a16="http://schemas.microsoft.com/office/drawing/2014/main" id="{07C08688-4E2D-A160-0CDD-D630CA559D82}"/>
                </a:ext>
              </a:extLst>
            </p:cNvPr>
            <p:cNvSpPr txBox="1"/>
            <p:nvPr/>
          </p:nvSpPr>
          <p:spPr>
            <a:xfrm>
              <a:off x="-486770" y="11316851"/>
              <a:ext cx="1556279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100" b="1">
                  <a:latin typeface="Arial" charset="0"/>
                  <a:ea typeface="Arial" charset="0"/>
                  <a:cs typeface="Arial" charset="0"/>
                </a:rPr>
                <a:t>Hemin</a:t>
              </a:r>
              <a:r>
                <a:rPr lang="es-ES" sz="1100" b="1" dirty="0">
                  <a:latin typeface="Arial" charset="0"/>
                  <a:ea typeface="Arial" charset="0"/>
                  <a:cs typeface="Arial" charset="0"/>
                </a:rPr>
                <a:t>:</a:t>
              </a:r>
            </a:p>
          </p:txBody>
        </p:sp>
        <p:sp>
          <p:nvSpPr>
            <p:cNvPr id="158" name="CuadroTexto 157">
              <a:extLst>
                <a:ext uri="{FF2B5EF4-FFF2-40B4-BE49-F238E27FC236}">
                  <a16:creationId xmlns:a16="http://schemas.microsoft.com/office/drawing/2014/main" id="{7215107A-E6E1-FBC6-B80C-55FED8CD8B6F}"/>
                </a:ext>
              </a:extLst>
            </p:cNvPr>
            <p:cNvSpPr txBox="1"/>
            <p:nvPr/>
          </p:nvSpPr>
          <p:spPr>
            <a:xfrm>
              <a:off x="4199896" y="10731212"/>
              <a:ext cx="606413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0.2</a:t>
              </a:r>
              <a:endParaRPr lang="es-ES" sz="1050" dirty="0">
                <a:solidFill>
                  <a:schemeClr val="accent1">
                    <a:lumMod val="75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9" name="CuadroTexto 158">
              <a:extLst>
                <a:ext uri="{FF2B5EF4-FFF2-40B4-BE49-F238E27FC236}">
                  <a16:creationId xmlns:a16="http://schemas.microsoft.com/office/drawing/2014/main" id="{124F2B2F-DE2C-6373-E37B-2D89FCD7DCA9}"/>
                </a:ext>
              </a:extLst>
            </p:cNvPr>
            <p:cNvSpPr txBox="1"/>
            <p:nvPr/>
          </p:nvSpPr>
          <p:spPr>
            <a:xfrm>
              <a:off x="4624170" y="10731212"/>
              <a:ext cx="606413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160" name="CuadroTexto 159">
              <a:extLst>
                <a:ext uri="{FF2B5EF4-FFF2-40B4-BE49-F238E27FC236}">
                  <a16:creationId xmlns:a16="http://schemas.microsoft.com/office/drawing/2014/main" id="{6B09E8BC-874D-1866-D6A8-C6D8F01FB8D0}"/>
                </a:ext>
              </a:extLst>
            </p:cNvPr>
            <p:cNvSpPr txBox="1"/>
            <p:nvPr/>
          </p:nvSpPr>
          <p:spPr>
            <a:xfrm>
              <a:off x="5055207" y="10731212"/>
              <a:ext cx="606413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  <p:sp>
          <p:nvSpPr>
            <p:cNvPr id="161" name="CuadroTexto 160">
              <a:extLst>
                <a:ext uri="{FF2B5EF4-FFF2-40B4-BE49-F238E27FC236}">
                  <a16:creationId xmlns:a16="http://schemas.microsoft.com/office/drawing/2014/main" id="{8A126945-EFB3-D54C-0755-A9F723D78F48}"/>
                </a:ext>
              </a:extLst>
            </p:cNvPr>
            <p:cNvSpPr txBox="1"/>
            <p:nvPr/>
          </p:nvSpPr>
          <p:spPr>
            <a:xfrm>
              <a:off x="2689686" y="10731212"/>
              <a:ext cx="606413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0.2</a:t>
              </a:r>
              <a:endParaRPr lang="es-ES" sz="1050" dirty="0">
                <a:solidFill>
                  <a:schemeClr val="accent1">
                    <a:lumMod val="75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62" name="CuadroTexto 161">
              <a:extLst>
                <a:ext uri="{FF2B5EF4-FFF2-40B4-BE49-F238E27FC236}">
                  <a16:creationId xmlns:a16="http://schemas.microsoft.com/office/drawing/2014/main" id="{AE6BF758-8AAC-2D47-71B4-091926132D64}"/>
                </a:ext>
              </a:extLst>
            </p:cNvPr>
            <p:cNvSpPr txBox="1"/>
            <p:nvPr/>
          </p:nvSpPr>
          <p:spPr>
            <a:xfrm>
              <a:off x="3113959" y="10731212"/>
              <a:ext cx="606413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163" name="CuadroTexto 162">
              <a:extLst>
                <a:ext uri="{FF2B5EF4-FFF2-40B4-BE49-F238E27FC236}">
                  <a16:creationId xmlns:a16="http://schemas.microsoft.com/office/drawing/2014/main" id="{231DC0A2-2B61-2A21-9756-2AC2AC9E2B0E}"/>
                </a:ext>
              </a:extLst>
            </p:cNvPr>
            <p:cNvSpPr txBox="1"/>
            <p:nvPr/>
          </p:nvSpPr>
          <p:spPr>
            <a:xfrm>
              <a:off x="3544997" y="10731212"/>
              <a:ext cx="606413" cy="562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>
                  <a:solidFill>
                    <a:schemeClr val="accent1">
                      <a:lumMod val="7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61262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</TotalTime>
  <Words>45</Words>
  <Application>Microsoft Office PowerPoint</Application>
  <PresentationFormat>Panorámica</PresentationFormat>
  <Paragraphs>4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3-07-17T13:35:44Z</dcterms:created>
  <dcterms:modified xsi:type="dcterms:W3CDTF">2023-07-19T13:50:16Z</dcterms:modified>
</cp:coreProperties>
</file>